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8"/>
  </p:notesMasterIdLst>
  <p:sldIdLst>
    <p:sldId id="259" r:id="rId2"/>
    <p:sldId id="268" r:id="rId3"/>
    <p:sldId id="270" r:id="rId4"/>
    <p:sldId id="271" r:id="rId5"/>
    <p:sldId id="274" r:id="rId6"/>
    <p:sldId id="302" r:id="rId7"/>
    <p:sldId id="273" r:id="rId8"/>
    <p:sldId id="269" r:id="rId9"/>
    <p:sldId id="293" r:id="rId10"/>
    <p:sldId id="292" r:id="rId11"/>
    <p:sldId id="294" r:id="rId12"/>
    <p:sldId id="296" r:id="rId13"/>
    <p:sldId id="295" r:id="rId14"/>
    <p:sldId id="275" r:id="rId15"/>
    <p:sldId id="287" r:id="rId16"/>
    <p:sldId id="288" r:id="rId17"/>
    <p:sldId id="289" r:id="rId18"/>
    <p:sldId id="301" r:id="rId19"/>
    <p:sldId id="290" r:id="rId20"/>
    <p:sldId id="298" r:id="rId21"/>
    <p:sldId id="299" r:id="rId22"/>
    <p:sldId id="300" r:id="rId23"/>
    <p:sldId id="291" r:id="rId24"/>
    <p:sldId id="285" r:id="rId25"/>
    <p:sldId id="286" r:id="rId26"/>
    <p:sldId id="257" r:id="rId2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000"/>
    <a:srgbClr val="00205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7D16C0-056E-FC4E-928C-1FA35D1F895F}" v="8" dt="2020-04-27T17:42:05.96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13"/>
    <p:restoredTop sz="89067"/>
  </p:normalViewPr>
  <p:slideViewPr>
    <p:cSldViewPr>
      <p:cViewPr varScale="1">
        <p:scale>
          <a:sx n="98" d="100"/>
          <a:sy n="98" d="100"/>
        </p:scale>
        <p:origin x="1224" y="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428E1D-0436-0A47-8119-FA6E7B6683B2}" type="datetimeFigureOut">
              <a:rPr lang="en-US" smtClean="0"/>
              <a:t>6/1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180F98-1214-F344-B3E8-EE2EF9F25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007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180F98-1214-F344-B3E8-EE2EF9F25B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0114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troduce yourself, talk about why they were selected to participat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180F98-1214-F344-B3E8-EE2EF9F25B7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16196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180F98-1214-F344-B3E8-EE2EF9F25B7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84707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larify handling &amp; maneuverabilit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180F98-1214-F344-B3E8-EE2EF9F25B75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77352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place current method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180F98-1214-F344-B3E8-EE2EF9F25B75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94243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180F98-1214-F344-B3E8-EE2EF9F25B75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1849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926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2963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379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257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110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197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513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0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916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337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829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3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6209E-B029-420C-B175-9AAC4935E845}" type="datetimeFigureOut">
              <a:rPr lang="en-US" smtClean="0"/>
              <a:pPr/>
              <a:t>6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6FA5C-CBD0-46DB-B557-FD59A6CEB2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28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10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6.jpg"/><Relationship Id="rId5" Type="http://schemas.openxmlformats.org/officeDocument/2006/relationships/image" Target="../media/image2.png"/><Relationship Id="rId4" Type="http://schemas.openxmlformats.org/officeDocument/2006/relationships/image" Target="../media/image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6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6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jpg"/><Relationship Id="rId4" Type="http://schemas.openxmlformats.org/officeDocument/2006/relationships/image" Target="../media/image6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2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2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2.pn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microsoft.com/office/2007/relationships/hdphoto" Target="../media/hdphoto1.wdp"/><Relationship Id="rId7" Type="http://schemas.openxmlformats.org/officeDocument/2006/relationships/image" Target="../media/image18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jpeg"/><Relationship Id="rId9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085" y="192129"/>
            <a:ext cx="4284908" cy="5198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AutoShape 7" descr="data:image/jpeg;base64,/9j/4AAQSkZJRgABAQAAAQABAAD/2wCEAAkGBxQTEhUUExMWFhUXFyAaGRgYGB8ZHBwbHxwYGh8hICAdHCggHiAmGxobIjEhJSorLi4uHyAzODMsNygtMCwBCgoKDg0OGxAQGywmICYsNC80LDAsLCw0NywsLDQsLC80LCwsLCwsLCwsLCwsLCwsLCwsLCwsLCwsLCwsLCwsLP/AABEIAOEA4QMBEQACEQEDEQH/xAAbAAACAgMBAAAAAAAAAAAAAAAABgUHAgMEAf/EAEIQAAIBAgUBBgMGBAQFBAMBAAECEQADBAUSITFBBhMiUWFxMoGRBxQjQlKhscHR8GJygpIkM0OissLS4eJTY/EV/8QAGgEAAgMBAQAAAAAAAAAAAAAAAAQCAwUBBv/EADcRAAICAQMCBAMIAgEEAwEAAAECAAMRBCExEkEFE1FhInGBFDKRobHB0fAj4UIVM1LxYqKycv/aAAwDAQACEQMRAD8AvGiEKIQohCiEKIQohCiEKIQohCiE8JohOXFZlatiXdQPel31VScsJJUZuBOLE9pLCCWJjz0mB6k9BSw8UoOy5J9MS0aaw9ppudqrIAJnSfzSNPpuD+9QHitZ2wcyQ0rmZntLaABYMJ+Y95HShfFqSODn0xD7K83tn1oEBiROwkbfXipr4pQw7/hI/Z7PSbkzeySB3gBPAOx29KuTXUOMhhIGpx2nWlwESCCD1FMhgwyJWdpnUoQohCiEKIQohCiEKIQohCiEKIQohCiEKIQohCiEKIQohCiEKITkv5hbXlvpvStutorOGb9/0k1rZuBFrMe2ttZUk2z0LKf2O6z86QbxC23ahf5jS6Qjdoj5p9oHKsdQPVTBj1EkfvXa/DtVf8RYj5mWM+noYZ3PtIS12qxDjTat3Li8HYmPnvHzP0phvB6VGbbAG/vb+JE60dX+NCZGY/N8VaPduugFQQhOrY8Hn+Ee007pvDdHanUp6u2eJTZrr0f7oHtPcL97NhrwZDZB8UsNm2Hw8g7jbrPrUbKtCLVoKnq7e/vmcTVarp83IxC1jsUFQd4jC98C6wN5jiQF3232munR6MlvhI6eTOrq9QpB2OeJ3Ni8eim3ctFlXcrE6R/oJge9UDTeHWkNW+M7fP8AESQ1OprJLLmYDtbd0BLynkFW4MdIJ3+c11vBai2aXHoQf9TtfiGN3T8P9yayvt0oKs5K9HHn5MI4bzjn6Qld4NqE+Gs59MbSxNVQ65JwY8Zd2rJcJ3gcMAUbofQkcz50r9u1NS/GOOROtpVZepYx4XPrTSDKlfiBHHr7etaKeJUtjO0VfTuslAa0JRPaIQohCiEKIQohCiEKIQohCiEKIQohCiEKIQohOfF41LfxECl79SlIy0mqFuIp592t7uYZAB/iIP7CKyH11156a8j6R2vSbZaVlmvax7mvuEYBdyVLQB5kAxHuBWjp/CACp1DDft3PtIWaxQpFQJPr2i0l65iLiWy5JdwoniWIEmOYmtnyaNKjOi8DP4RFr7byEY7Sd+74e1jDhLllWtkqmslhc1MAQ0gwASeAAI/fNNmot0n2pHPVucbY27Y+Xf1l4SpbfKZduM98yYweXRbxuCuO7KgV0PLaSNQgExIKjbYSfWs67Ulno1aAAnY/PMYrrwrVE7CJWc3EN1u7P4X/AEx+lW8en0hmYR0r0ujVxUPMGG7/AD4zMy7HXtx2k12HxCs13C3PgvoQP8wB/lP+0VneNUsoTUJyh/KMaJgS1R4M5cIi3MfZtqZS26Ip8xb3J/1MGb/VVtrGvQPY2xYEn5t2+gwJxQGvVR22/CSXafEIbt1rOo39bI8wYtrZ0tAHC+Ikk9V9KS8NqYVIluOjGR8y3f3447S/UuOolOf2xN2WZjc+44m+7SSVt2xyqwFUaVOw+L9qjqdMn26qhB6k+pySd4V2saHdvkJzZbhbWJTEX7toBERYCeA94E8UafDud9weRVuput0r1UVvuxOc7jBO3Pp85GtEuDOw2Ej3wLIbQs3HR3uFe7YwUcaYkrsZLDoPXg04L1dXNqgqBnqHcH2Mo6GXARue0m7PaXEYe+v3q0QTs54lfMAbGOdj/GsxvCtNqaidO/yHvHPtligJYuPeOnZ/tJ8YtOHVfGg1bFOq+n8vlFZvmajSMvVn0MZemu1Qykbx4yzNkvBSpgsJAPUVr6fWJccDY+kz7KmTmSFNyqFEIUQhRCFEIUQhRCFEIUQhRCFEIUQkRm+dW7YI7xVbzJG371m6vXivKJktL6qC+8q/tR24jwowYnyEfxJpfR+GW6puuwkD3jVtlemA7n0ihIuPbv4ltVt2KsqN8HhldUcSTMDeA3ERWyqeUrU6cYYDOT333x/eYm9psYPYfhPYdpLXLve4AXbAFtrMrdtpsjKwgkrw20GTP5vKlFQU6/y7viD4Kk8g/Pt6bSbN1UdabY5ETbF0qwZTBUgg+RG4/evRMgdSp4MzlbpIIjDm2cYfEXLd9u8t3VjWqqGVoMiGLCPKSDtHlvj6bR6jTo1K4KnOCTjGfbvHLbq7GDnIPpib8JmONu37t+xYJa4InSSFURABJC9Buf2mrR4VT5CUvnC7+m/r/ErOtYWM47zC32IxbmWW0k9JAH0QED5VooVVekfzFWck5ndh/s/vqQwvorDcFdUg+h2oZlYYYbTgcg5E2YbsNibR1WsSqtESNS7fLpVdi1WL0uMj3EktrKcjmY4zs7mOl11W3DjxFdIZuDuxRT+9UrpNOrKwHHG5x+GcSw6mwgg95H5gmKt4X7tcwhRA2oMknff4jLAzPmOlRTQKNT9oDknGMHH5SR1INXl4m/Ls6tphrdqxc7txdDubkqHAMkBlkAbKN42FZ+o0Nj6lrbl6l6cDG+PocRqq9BWFQ75zvtOvIMsW3euYu9cDpbBPeD4WuNOor+oCYB6k+lK+Ial3pXS1rgnt3wPX58/SW0U4sNrHP6Z9vlDtU9uxbvWXZrt684uyRCoJgRv0Cldv4VLwuuy+1LUAVEHTj1+c5qiqKVY5J3i5l+Gv20OJSURdtR21SQsD9Q8+m3nWvqLdPaw0z7k9vTH6ROkWV/5V7esa8g7Vq9nu2JS8j6rcHY7yRPPnt5H3rB13hbUOLKiSO/rNPT6gahyGwMyz8pz7xKrmVddSN9JB+RkfOq9D4hylx47yq7T43WMaMCAQZB4NbQOd4nPa7CFEIUQhRCFEIUQhRCFEIUQkJnubd2JVlAHJJj+prJ12sK4So7xrT0dZ3EqXtJ2pu33NmzHBLMDAA3kkkCAOT0FT0Xh6qo1GoJ549ZbdcK/8dY39fSQuUYm1hboB7q9bcQXKGVkeTbhZIMx4hv6Vo6mq3WVHHUjL2yMH8O/t2MUrZKn3wQe8kjisAxuW7tpsM5GhwviSeQRp22O4MDb0JpIUeIKFsrcOBuPX3G/4ES4tpzlWHT+kgsozJ8K91LYW6XGgR4kbfnSN224EjkzWtqNIusRC+Vxv7/LPaKV3eSWHP6SVynsNeunXfIsqfyqo1fIDwr/e1O5CjAOfz/OKFi0css7M4axuloFv1P4m/fYfICoFyZyTNRhMgB1pTWWCuliWxtz7y+hSzjbMwBrF0nitmouRHIUd/ePXaRa0Zl3MzitzVWdFTMDg42PvEKU6nAxmYqax9L4q+otRCAvr7/L6x23RrShbn0nsV6DiZkjMzyDD357y0C36h4W+o/nNSDkQxFDNOxN60H+63C6MIa2TpJH/AIt84jpXWFbkFhuJNbHUc7SKx+bC4+rE2f8AiLahAjSEaGnxj4gYJ2mD+xzk0D0ApU2EYkn1G3bt+8cOoSzDONx+clO1N0pgrKEMGuuXKsQSAN9IgAQNSgADgCs/wxA2sdtsIMZ4+u/f1jGpJFIX1MjmyS2uAuXG/wCdbuAGPyz3YKHzgGfQyOhpoa+xtcta/cYfjzv9ZT9nUUFj94TuyftNcsfd7WIUgKwKXOfw28zMEAE7g8bdKW1fhteo6rtOR3yPcS2nU+WOi0HfvLQybPO7Ny28G2jbN+lW3+YBn5e1Z2i17VhanG36S+/TdWHXkxvBr0Ez4UQhRCFEIUQhRCFEIUQkPnmarbBSdyu8cgegFZmv1hr/AMajcj8IxRSXOZS3arO/vF0WbUrL6ZZm5mN5O2/kPrVvh3h5pU6i0ds4l1+oAHlVnfueMe09RbmW3dDoLmGubM2kHVIE7x0M+A7QTzzXc1+J1dSHFi8DJ/T9+0p30zYI+E95vzrA21Nhwts4RYIuSSdMlihBJ1yT4QNxv5Gq9FfaRYhJ809vfsfbHf1k7q1ypx8I7/t/EhsFl93HOEtIFt2xp7xhvpHGtuWaPyjYeg3reooFOWY7nn0z3wJnW2hth2/GWFkXZ2zhR4Bqfrcb4j7eQ9B85qbMTKJLRUYT2iEAKITIVVZTXbjrUHEmrsnBxPYH9is/T+G0oXLKDk7ewjVurdgoBxtCnbNNVaAHXIEXS50+6ZiVFZ+m8JqRmLrnfb5Rq3WuQAp7bwitYDAxETuczwipZhPYrkJHZzklnErF1dwNnGzL7H+R2qSuRO4iBmuAv4EgMBdtCRaf/wDGxHK86GmDG4Mbb8V2aWu3cbE84747H1l1eoK7HeZ5RiUGXtbK9473iVtzzpCMS3kgiSflNZOsqc68OD0qFxn57YHvHaWX7Pg7kniYYjK0azhrlwPcfEvBcNGgtxCxBjeQf0njp1NYwutRCFFY4xz7k87+3rONUGRWbJLflN3ZbP8AublyxedWUoUVxuNQ4Grqp3APtUPEPD1tqF9SkHkj2ktPqGDitzwZbHZrNo7q2x8L2wVPkwAkfMH9vWs/w7VlWNVh+X8S3U08sI1VuxGFEIUQhRCFEIUQnNj8RoQsASegHnS+ptNVZYSSL1HEqL7QO0dyRbQgsxjSPFv8uTMCNx9KzvDdKdTYbbzsO/aP2WfZ6x0j4jx/MXMFkeFuWdRxRW6DDkqdKk8SCAQOmokAn6VpXa3V1W9IqBUjYZ3I9v4iiUVuuev4u8mcVijh1QYhkv4a6pDkeIBwCZH+eAY/VqIIrPrpGpLGkFLFO3yJ/Y/iNowzmsAWbqf1i/l2AbFS5DW8JZk6VliATJCz8TmZLH+gr0tdYoUs27Hk+v8AAHYTLewueleI+LZS7gyuAuBAB4SuxB5gzuGPWd/OoM3mLlTIgdDfGJw9l+0rO/3bFDTeGwYiNZHII4Dj02PT1qrtP3W5lltIHxLxOuxn5GMfDXlCyfwmE79QD6kbg9dx03kLT5nSZE0gp1KZPRV0omQFRZgoJPE6AScCYs1eS1XiNgtfySelvb9Jt1aVSg8wbiZCvR6K2uyleg5x+MytQjK56hCm5SBmYs/lXnvEfEfJuBpbJxgjke009NpQ9Z6x8oIZp3wrUC6rJbLd5RrK+hthtPTWpE+048FmK3bl22vNpgCfUif2Mj5VEMCTiSKEAH1kJh86NzMzaU+BbbLHSQVJP1lflVSv1WEdpcU6agTyZM51jLNq0e/go3h0katU9I9quLhNzKlrLcRDz7JHwLs9sFsNdUow6gNI0k/uG9gfWV1S6hR6g5HzElVaaz7HYyKzLOUOFt4a0H0qxYs8Az4jACkwPEetJ0aBxqW1FuMkYwM4/P5S+y8GoVrn5mQJrUJ7RSWF2Cz83GsYd+bYcKf1LpYwfUD9hXlfGvDynVenfGfb/wBzW0moXoNbcy2ezGZ97aCtOtJUz1CnTP8ACfU1bodUtqBe4Er1FRRvaTVPyiFEIUQhRCeE0QiP23zvu0eX0rwNPPzJ2G/TeawL7G1N/lpuJo6atVHW3A9f2lYZGbeo4m+7qrObdtl3NtiCdR5iBsNuZPrWtqlsVRpqFBIAYj1wePf3i6MHY22HnYe0wzTJsVauC9bc31bi6vikf4+ZEckyCOas02u0tqGmxegj/ifX2ldlNqN1qcj1nJl2XjG4gJZt90mzORO3m25MGSQq+3rWpSj1Lmxuo+vt2H8xO11Y/CMCWxgsElq2tu2oCKIA/r6nk+dcLZMp4iV2ky+5g7v3nCnSGMMv5Z5gjqp39t+NqSsXym6l4j9LC0dLcyOz7EW8ZZGKtDRdQqt5QdweEcHynbV7eVctIcdfcSVQ6G6Dx2nFnGcm/as3ZjEWjDHqdJBR/wB2n1B9Kiz5AbvJLX0kjsY55F2iN/ElD8LWFdR+lgBrE+7/APbTFdhZvpFbagqZ94zg1fFxtPZpW3TJZalh/wCOf0/mXJeVRlHeBO3NR19vk0FwcHt7+0lpk63AIyJgrVnaHxF9VcFbAAHHqYzqNMtNeRuZkdxFaGr0aX19GBzFqLzW2SZrxN8IpY8KJPyq/wAuusdQA29hIZaw4JixlPaBvuV6/caStx1Sevw6ffcn5CoJYRX1GWtUDaFEXOzOa9xhsRfk95duaEB/wrJY+2vf5edVo/QmZbYnW4A4E6vs6w3ivYu4dKKuhSx9ixPsI+ZNTpGB1GQ1DZIUTxsy+/5haSCbKMSBxso1Sfchf2FcVjY+e0Cnl1+8fcWbZHd3NJ7yRoP5tpO3Xam+rBiuMyq8+yJMLiQt3X3DyVZSJj5g7qSJ23G/Wp2NYayasdXvO19PVhuJI5DluGNs4i5ZC2rYIcXCzMWERHwqQQR+WZ2rz+t1Op8waet8sx2xgDHv32+c0qaqivWV2HrF05iwvm/ZUWypDKEWFQbAAxtvsD5k+tbS6dRT5Nhzkd+TEjZ8fWoxiWt2OzUlcJdgePvSwB6SRH1X9hXk2xodY3cDA+k18+fSW9cSyrF4OqspkMAQfQ7ivQKwYAjvM0gg4M2VKchRCFEJH53iAlpvFpJHPOw5/aktfcEqIJ3MtpUs+0pHtdizib64e2DqLgb8+5PsdRjYAVDwupdPU2pfYAbf38o1qyG6aV57/wATeezqXLdyzbs3LN23p8dxjpuCeSRKngmANtqrHibpYtzuHU/8QNx7Ylf2ZWUooII9e8hcys3cJbNgXlfvviS2S2kA/LdjtEbgVqad6tbYLvLI6eCe/wD6i79dC9HVz/fzj/2SyT7rYAI/EaGuH1jj2HHvJ61oO2YhMc17O62Nyxca1dO5KkgMfWP5gj0payondTgxiu4AYYZEX7vaG5b1YfHprQ7F1ADDyJA8LDqCI46naqPMP3LBGPJH36zFXEWu6ukI4KOCuocOrcH6gH0ZfSqD8OQDL/vYJE4bywxnqpP8f5iuDcSRk12OxfdYhLjHwrauEn0Cao+sVZQcNkyi8ZTA7xy7GZxrsIL1ybr3LmkE7mPEY9BJ26cCm6nyozFLkwxxwI0VdF57NUW6aq05dQZbXc6fdM8ApHSeF1Vgl1BOTj5dozdrGYjoO2J6K1IlzFD7QM6Fu13Snxtz6f3/AE86Vvfq+AfWOaavHxGV/mOYkYe3ZXZVkkebEyxP/iPQepqjqzgdhGOnpy3cziuXm7tUJOwgDyBJP1LH+9qCcmSxgYklmGeObaWV8FpB4UHHqzH8xJ336ngUFmYe0Aipv3jT2b7vL7BvXv8AnXhK2/zBORP6ZO5J9OophWFS78xVgbjtx6zZ2Sa7i8W2KufBbBC+WoiIHoFJ+o867SCzdZkbiFUII09ocpXFWGtmA3KHyYcfLofQmm0bBisQMAGxFv7tfvdyuGJL6huVG0TMSh28vEOYrJ1aDR3G+qvqZ9h7H/Y/eaVTG+sIzYA/Mf6koy4e3aRMPZV0xHgZ3MXWGrSSqkajxqB2URNZy/aLbS97kFNwAPhBx3PHt3jHTWigIMg7Tn7E402MRcsO4KolwoZ2LbHw+jL4qY8WpS/TjUgYJxn++0r0jMr+SeMy3eyGM/Ct2W+JbSsP8p/ptUPDtT5imvH3Yaushy/YmMNacVhRCFEIpdrseAG0gakB8R4U/wDumIHNYGvt8y7yx22/GPaVMbniUZbbEXbjXbSXSWMakVjG3GoDmP73r04GmoqFNhGB64/SJPZbdYbFB+kZ8rx+MK93isM12wdma4sFV6kkjcAb77+tYmp0+iLeZprAr9gO59PaN1W2n4bFyJp7DZauJxj3hbC2rR1KgG2rhB6kAaj6gedehQPXUFZsnuT695luQWOBLJYVyQxI/OLd5k/AuBH9QDP+4Ef3yKg4Yj4ZNOkH4pW+dZlidQTFANp2J0BWAPQ6YEf2DWfYzNs3ImjUigZXiRHc6hoUiCZU+h/mIqA2ljcbTmu2yQpJ30tPyLfvRxxOc8zBU06dW4Xp9P3iK6TniAX1nZk2aNYv27sau7DGCYEuG/aWmpo5Q5lT19QxLU7I4y7ewqXL58TliNgPDJ07Dbj9op+vJXeIWhQ2FkzU5VFrtzjzbsgKxBIJ2McbDf3M/KldS+MCOaavOTNWedrltKFQy8CTyAfTz368VGzUdkkqtLvlpWGYYx7jm6x29Tv/ABk1SBgRkk52nC76jvv/AHsP79a7wJHkzIXPEOp5/p/fpXMbSWd50YW5pcNO6mdxO442OxrmSOJ3pB+9J/C5cbv4+Lum3bbfczduf5Qd4/xHbykb1NUUfE5lTWE/DWJM5PjHxWIt28ODaw1khiqkgaQdXi/UzEfx53NXVku22wlLgIvqTLEpqKYlc/aLl3d3kviQl0abmnzHP+5P/E1aPiT3HE6uzTZgMkwiuQ91sTdCatIOldOmRJmBKkAamjcbRXmb9drHTKqK1zjPcnvgc7fKatenqB3bqMh+0N0t3eJt2+50t3QCMCJQAqVZdjsSu2w0xWhoE6erTu3VkdW49djnP9xKbzxYox2lpZHmk3xfTe2/d2VHmHIMj2kfvWBo2bT39B5JOY/aosqwD2zLBr0cy4UQmNxoBPkKixwMwEqD7S8yfu/i0zwvXc8nyMTA52PFY/hqefquqwe/ymi58nTsV54zFzKMDfwtpryXkJCa7mH1bhImT5MFM8fXgu6rUafV2Ct0OM4D+/8AGZRSllSFgR8pozfOrrWdSXi1l0Foqx/E1bsxYAAAxtI2giOsX6TQ0pd0umHB6sjOMdsb/ke8hde5TKnYjHv7x27B4DucJbP5rn4h+fw/9oWtWzc4maDjedd7P1GJ+73D4ioKnoQSYG/JEfP1I3VsY1YYj4e59Pf5S9FFg53kmDV4ORkSk7TgzbKreIWHG/RhyP8A49DtUHrVxgyddrIciVdnWVthmZNviDKd4nfj0IPHnIrOdCrdLTRRwy9QkS94ncDYkwOOqk/uD9a53kxDFXAZP0H7k0LOmcwHh3+Hk+belBO8iNhGbJu2V6ygtSCWcQ1wswRIAgAbwIJ59AKZS4gRaykE5ljZHnVvFKz2g2lXKSwiSADI343ppHDjIij1lDgxS+0TE/iBPJBP1J/uaS1O9mI/pRisn3iA92Sd+d+f4niqwMSwmc3EbzH0FTkJpZt/CZ9TXcesjnfabEby68muSQmxImBvXJITvwYW434twog5hSzH0HSem5AHrxXV6f8AlByxHwx/7I52jOuHwmGK2l3uXGbcbctAgsTsBP0A2ZrfqOFG0StrC7scmO6x1IHqavJxKAMyF7V4MX8LeVfEVXUp/wAS77SN5G0jY6qlW284wxK3ymwl4Ja7q6zMGBZXIDFQWQGQw2ELO0Aikda9mnLWBwBtgEA7H7x5BjlAWwBSDn5/hOjtDlFmwihr1w39O1rULgX3bSsD5f1qnw/WajU2EhB0f+WME/mZPUUJWu7HPp6Rn7AZgLtm1aBg4dnuNvvyWU/Vo+VZfjNb06g3euMfONaN1NRXudpbuR4s3cPauNy6An3IrVocvWrHkiK2oEcqOxndVsrnHm11ltnSJPH1/lSutdlpYrJ1gFgDKO7e3la8lsS7F5cjck/DC+m8Dzj2inwVOlHszgYxk/jmNa04VEPzx7QbO7DXWW9gHS44KHRs7Bto4UyR70fYNQqB6rwQN9+Mjf3kfOrLEMhBkHm+Bsm/atYdXUPpB1zrDOxEEHiBH1rW8Oe9qy1xBOcDHGB3+piepFaEBJcaIAABwBAHoNhV5io4lX/aUCuLVvO0p+jOP5VYv3ZJciTnY7tV3mmzdPj/ACsfz/8A29OvvsULFOk+Ib1n/wCv+v0l+Bd//X6xymmgcjIi+MbRL7WZFeY94jG4szDEnTvO3pPl9OtJ6ipvvDeOUWr93gxG7giFjfdYOx3Mz9KUJ3jomq9B1dC0fTj9zFCzje003/XoefKI4/rXRtDtNDiJ/c/yqYkJK9j86GGxFtm+A+D4iAoYiWIAMwBx5xVyN0nMptXqXAnZ2vxve3XPm23mF6be0b0uX6nJlyr0IBFpySef2/jNWbSJ5nM14hjHPsJqW0hmeMCdzJPsTRO4MyA9Cf2FczDAm+2JHE/w/v51EywTbaI1DXJXqAQD8tiB7kGgQOe0unKhYsYVHVRZtaA51ciQD4upbgeZpx7kqUep4HrM0I1j8/WKuY9pbmIxNiygNu01y2Y4Z1JVgT6EbgV2rTlv8tvPYdh/JljOFXpr/H+8R+VY26fX6k1dFuZWOTrftX8XhcOVVyfCW6BGjbY7lGmfSs7xevT/AOO68EqDjb3G35iP6J7MMiczEdlFRg2KxllfFLLqlm33Ekqd/OKXPjDspXTUN7HGB+Et+xb5sYTb2FuBMRfw0+K6e7Vh5Izav+2T8qPGVe3T13dhufqP5nNGVrtOZdXZK9qsED4UuMi/5REfSYqHhrs2nBaS1a4s+YB/GTdPxaRXaKe62bSJ8R6xBmPXoPfrxWb4p/2d+My/T/f4lK5xiVuZlZ/ItszJ20qstJn/ACyT5k1LRq40FjDfPA/LEv1AUXoudxyZnbyXDtZKLicK7lp7xlUNBBmSHkmd9RnrUDrNQtoZqnVf/EE4z9RxI+QjKfiUn1nPgrLNm1pHbWbegFvMpZBn5sJrY8P6TpQyjAJJx8yYjq8+YQe38S0RV8WlS/aViNWMIH/TRVP7v/6xVg2XMmoithnKtG8HdT68xNCHDFG4P9xBs/eEs7sj2mZm+74iRdBgE7FiOQfJx1HX3+JB0OjOR/2z/wDX/X6S/a8f/L9Y4jzFNggjIixGDgxWz7smLhL2iAeqHYf6T0+f7UpZpc7pG6tVgYaJOZ5S9podSN5g+Y4jzHtSbIU+8I4jq243kTet8fLY8nr8hvXRvJczlvtIPz+XtVgErbie5ThNThzso6nqR0E+VcsbbE5WpLZM25piAXkAdeff0G3WuVrtJO0j1gjj/tn+NWYxKyczAIIruTO4E90+9chiHd+f7/0muZnAPWTGRZJcxF1FVG0kjU+nwhepnccf2amiMxkXsVBzLGv5Ll+BUXXt6j+UMdbMfRT4fnG1SchW8upep/09yZQvXYOpzhf7+MWe2eOvutm5cdALgLJZVg3drOzNBIJYbgn1ECIpjT1CtiTu/c/sPQSLtlcLsv8AeZsyjGvi8ysuU0d2OAIhFVivzgqJ6knjir1+7KWI7SzRUZASs8/sKM0cO5RLi+JgYgNZIJ/3Cq9b1fZiyDLDBA9wZfpiOsAnAmZyHAW7K3mfEvbYwp0xPy0Aweh4NYn/AFHxCy41L0Ajc78fnHzpqFXqYkiaMrxCYfNPAhCsNKLEEG5aXSIPBkgfOmLls1HhnxHJ7n5E5lShU1Ht/qXF2LOjvbI3FvSSfN31Fv5Ul4Q5ZG9M7RjWLw3rGeteJSJ7S6e68RIAMkDkgDj06b//ANrM8UZRUM+sY0wJfaUZndnvcfF1GCC3qKqNyiqzgKB5jwimtE7U6HKEdRON+ASQPy5ndSqvqMdgPxxNj5lhmGhssKpxqUeMDznQDP8AqqA0+oU9a6oFvTO364nPNqb4TWRDsZh9GZlCSxTvBJ5MAqP2rarfrpVgMZGYhYMORLTqMhKZ7bL/AMdiQepU/wDYlWLuCp7yXvPMPnNg4AYZ7KteW7qDBQsr4RDMNyxGoSOgANVVEk4Mm6jGZMYkNmhv4hWKmwgCpG76Z3TgCfiI5BPWRVgYY6cbZkcEHneSnY3tXrizebx8K36v/t/5f5viQdG0ZyMmv/8AP+vbtLwBePRv1juu8RvPEU2HUjqB2ipBBweZvvZELq6boGk9Duf/AINU2WKRjGZaisN84iV2t7AJaw9y8t5yV3IgDwnY8deKSKBdxHUtLHBlf2crtzLF29OBt5x/CoNacYEvWnfee4zFgeFdo+EDaB/fyrirJdQEg7hnn50wNosTmYOYEbifWuzhM9B9P6/WuSXaHB5+u37iic4jn2f7CXL9kXHu91qhkGnXKnz3WPTc0wtIIyYs2oIbAjhmGb2svspYT8S4iAKpPA/U8cTzA3PoKirPefLo4HLHj6ep/Kc6Avx2/hEzMMTbxFkO125dx927pS2q7KkqIABjqSASvXyksIq6f4K+O57n3zIOTYMn8JCYy2qtdUK3xBNbHWEjkSs77QOYFWnA2Tv3kBnbqPHaOH2b2dV69cPKoByTuxkmSSZ8Hn1q20YUCVncywhVEJXXa5Ac0sgqGB7uQeD4iIOxqOpJGlcg42Mu04BsGfWZYXNcddv3DZeyyqsGCTZTmPEVBZtp1CR8qwH0ugpoUWhgx4/8j+B49vWaS23s56MEflInKbzJmdp8TBY3ASRDAllIQjTsRJWI8vStSxUbw9l0+wC7dvmD7xP4vOzZzLn7Guwu30jnS7f4WaQB/sA+YNYvg5OGXsMf7j2sGyt/cRsraiMh+0wTuwX4UyR5gDg+kx71l+KdIrBPOdozpQS+BKM7RZhew+ON4gB2tys7wHDbkeYk7U74fpq9Ro/KbP3t4au01X5XsMCaB23xf61/2L/Sr/8AoWj/APE/iZR9vt9p09isYbmZBzsbneEj1IZv5VoLUKqgg4AxFXfrYsZa8VVmRlQfaLC5gzMDp0oTp2JGkAxIInY0EkfEJYmCMGcHbTKkwuJiy4dHRWWJkflIJ4nWrcExx0qvqOeriSx2kV94OkgNCsRqHPHWPT0q9viHUPrIgbxk7UHB6rf3SBC/iLDyHmT4mkEQYgHaPWuoeolWnCMYI2ljfZjmfeYV3vXF1I5WSdwukGWnqZO/WPOaQagVN0Jwd8enyl5brwx5kng+1tq4zeLSoPhEeIiOWH5Qeg2Pn5CSIH2XmcYldzxIztv2kQYS6E3LKV+IA7mPUnYzAH05HbKiqkmdqcM4xKju4rmIE+nr9KQ6BNItOHEW2Ikb/wBPrVgIB3lLAneRRumYMir8SjJnprkJvtEnYbk7Afyjr7VzEkDjcyyOxHYwqe+xKbgg20JOxGoEspA9IFXKq1jrfiK2WFz0pJDtP2wFubWHIL8Nc5C/5fM+vA9ehXVZq92ytf5t/AgStPO7enYRVx2c4VcCUCm5jLrFmuMFbuxKgieRqC7cncnbUKvdvLbpTYAYwJz746m5nEtlsLdsMx+7M1oMWLAvDbkkRKE8AEbj3Iqa+WRvIfGM4nTkVq/hls3gi3Vum53NpwG2UQbnd/EQVLAeXPlPat8jJwIPt2jN9l51W77edwD6LP8A6qkzdRlbDEeAahIyr+3ON0ZgHEEoqbHg7TH0NTaoWVFD3llbdLdU473aCyMP93sWXt23abhLgsRtIBg8gASegiN6zE8NuOo+0XuGYcbbfh/d944dTWK/LRSAeZn2exyvmOGZLbBV8CoTqM6GAMgD8x1TG254FGs07porAzZJ3J47iQR1a5SBgS5exoYXrwG6D43/AFXSQYHoq7fMVk+EhviP/GP6zHSuef2jbWxiISM7RIhsnvPhBB943g+h4ikPEunyct6y/T9XXhZRX2iYd++t3bhH4qFgvVfESJ9wQRTfgbqa2TvnP4zniC/ECOAMCbMn7I27uE75rpDlWIiNK6SdjtJ433EVTqvGbatX5Krtt8zmdr0StV15kJ2VxXd4uw/TvAD7N4T+zV6F9wZnS7wKUhKk+07fGkf/AKl/i1SX4hiTHEjMP2eD4B8St5Zt3NLoZEAhNOnbc6iZ6bjfzj26ZPkxdVoO/wAxUFbHynSIwW81spgjY7oG4W1rcgHSSyhxLGV1Ii/D1HqamxC4IkVBOY6fZswu4W/ZUAsbgJJ4hgF5iJGltqwvFarH1FbLkAjGffnH1jmlZVB6pP4bslatWQ9z4mY6pbTBLQAN9+nMzV1F9ulw7Dbv6j3+XrJ6gLqGIXtxEft1lF6yVurL4cD4h+U9dXyiDxzxNaWoc3gMDtiJ6YiokHmJougx/frSfTHg+Z0A7H6HeOv71DBlvE58RhgdxyKmrEcyp0B3Ez//AMK8bPfKodBOooZKGT8S8iRvO4g81cFyMiLFgGwY9fZv2XAVMXdENM2oM7EFZIE7mdgIM8idq6XSletz8hIN1WN0KJI9t8yui8uELdwjhZeGYsG4EICYnaBz1NSpqNo867gcL6fP1P5SJYV/AnPr/ET+3mFw+GvC3h7puiCLkMDpYGCogbHnczz6GWftLsN5WKgJhlaYK5iC94mzbVDoA2L3PEVJ8PhE7ydhAHWKLTjDATiA8ZnuV5TfxIdpFwCyC1y489ymrcajsTDsYngNt0IMLz3hu30mWaYy5l127Zw18P4FV3UGN9BYAHbcwNW+x2MzRZYCo23nVU941fZSkYS5tzeP/hboTiV2cx1qUhKX7W4jXi77D9ZA/wBPh/8ATTCjAnRGDOcgwdvBC7bbxwul9ZOskiRpmPM7ARFeY0fiGts1prcfDvtjgeuZq3aalaeoHecn2a2WOLLKNlttLfpmBPvyI9/KnPHrAumwTyRF9Iv+SXN2DSbd24D4HfwjrAHxH1YmfaKS8LUirJjetwGCjkCNFaUTnHm+HV7TqwkRJHtvS+rANLZGcSypirAiUx9omEa7b+9EwBc0Kn+Hif8AcIj3pXwK1Vs6DywzGNenwAD/AI8/WIK4lwpUOwU8qCQp9xwa9O1aFuogZ9Zlh2AwDPLYb4lnwxuBwentxUiw4MjiXvlWLF6zbujh0De0jcfXalGGDCV99rWAIaziANiO7Y+oll+oLfSuE43EmnpFjIMtbEv3a3FTwsQrNGpoB0gR4iSi7ek9BVmxIbM6cgECRWNsaHYHoSDtHFV2AA5EkpyIyZMWxFi3hittkF9JMDvgjFVJG0kDbxHiI6ijGBOHmWn2gzW1leFHcKg1eG0g8+rHqQBuT1MCd6StbbfkRnT1db4PErzD2cbmV6dRuAcs3htoPkIHsBJpXoaya/XVphtLHs5bcw9gG9eW50bbTM7RufEenSfKaKydH7p3Hp7j29pmXdGpbKjBil2h+z/D3la5hwbVyCQF+BjB2Kn4d9torSwjrkRIMyHBlYYfDu15LR2JaCfLkkkegmlWICkx34sgSTxt22BCKABvO5Pz3/lS6dR5jLdKjEluweORMXb1MyqQdWgjcaSQD5iaYqDB9otcVZN4/wCdZfiu9s4nBlb9m2wbuVhGj83JhiQW8iJ45qtqGFnWxyf7tJU21CspjGe80faJgExtu29jV95UeFSCpKnfSwO6sDwDuDPnIfoVukntELWVWAiB2Qy20ly8MXaZ72kpbtECFbfUzA7eDSDz6QSat8pwA3rOFlkPleS3cVcK2tLMpGxMSOpM7qsAmSPOok9WWJ4gMDAxJjJMtxJsYm5h2KWV8ThHjURsFABkjTcaJ8Jg9QKtIVdsbznxH5SAwGYMFdAqw0y3WNoj9+fPpUa7HOV9eYMgJDS3ew+ENrBWgRuwLn/USR/2xUpWxyZKZlixatXLh4RS3vA2+p2roGTOSlBh7jmVR3neVUtJ+Qqb3117MwHzIk1RjwJuXJsRBY2LiqASWZCoAAkmWAHApc6/TZC9YJO2Ac7ywU2EcGNf2eYcraxF5v8AlNpSB8TssnSPSHA+e1Ynj9ilkQfeG/tgxzw9T1Ey4exeEZMMGZgWunvDHAkKAo9lAqzQ1eXSPfeS1bhrNu20nqci08NcMJWfanAJiVxNuNCWUISNgLslh7iRBrBou+z6rzP/AJYxNB06qAvdt5WXZ/BWGS5exLN3dsqNK8szTA8429PfavReIX6gOtOnA6mycnsBM/T11kF7DsJ3X86t3VOFw2EVVu7DfxlvynbyMTJO07ilq9BbSw1OouyV/DHccyxrkYeVWnMafsxzHXYew3xWmkD/AAsSf2bV9RWq++8Rk92nykYrDXLX5iJQ+Tjcf09iarEAcHMpLDXXs3ARqRlMg8FSOv1rldgG3Il7ow5ElcC+FXDXUuWy11jNtwfhIBieNjq48wpPFWMmOOJAGTyYqzl9rDhrP/FJc75LiHUj2mKCdWuPHbDAQIBEwNU1RuQR2lm01dqdWOzA27C60dU7sL0QqLmr0HjLHy4pFwWeadJSujfg/rHTMs2XKcGli2oZjsjdGb87MJmeseoHFW2/CoK8xakedZluIj4DA4zMLhYFrsfE7mEWenkP8qj5Uv0GyaTWV6fjiWXgstOHtor3u8bhtj8o5JPSeo9qXGpGjsKDcdx6H2/iZ9wGp+IDEQO1eD04r7yLRt2xCeMBCzs2gsFJk7Md49etSGrW5sdz6fvJJUVXc8RKewzuiAqC+kDUdK7jSZPSDTVYJ7Tlrd46YHJbGAvKGuC7buKF7+CotsT8LKTAUwPEZg87TTgWypuphtE8pavSp+KWJlltrZiYI/cfX9jMefWpuQ0qXIk3aug7kCfP++KXIwMCTB3i72s7MYG4LmJxKunh8b22YEgRyokNwBweBUlZzhRAheZVWC7OX1Fo2Lg73EE6La3AtzQBqDN4gF23iZ22FNqUQEESB6jvIztDcv4V3wZugqGOpbbDS2qBLeukCNW6iOKqsfqYETqjaSGZZThguGs4Nzeu3FJdp2LFioWIBXTp8hsZ61ZUMZ9JFzLWwlrQir+lQv0EVIymKn2k5jpsrZU+K4ZI/wAK/wBWj6GpoN8zq7xYwuPvYA6RdVlceO2rgsjETwZ0uPYjbesq7TUeI5JQgjgkbEfPuPbmaCWWabvt+k255nV57UreD2HUW94DlwAzkqB4TtB6QwiZ2o0WhoS3DJhwerI4xwMHuPz2luo1DsmQfhO31jRkOHNjCWLQ3vXoaYkWxdIA284I9TBjisrXsNTrCBsMgRnRp019TfPEt/AYRbVtLa/CihR7ARW6ihVCjtM92LMWPedFSkYUQir2jw837a6PAx1u0bEoOD9BWJ4imLA/bH5x7TNhG334H1lK5raaxiblu0n4V5vAjDwspO0GR8LErIIiCPOt7Tump062ucFe45Hr68jmIujU2GsDI9Jty7CXbl1bLXO41H/lWQA+25LRxA/WSfQ0vfdTXUblXrx/ybJH09foJdWrswUnHsB/f1m45kmEzJ7luTbDaX6yDGv3ht/cU34eXfSJ5vOPy7fliL6kAWnplsKwIBBkESCOCOkVbKMSuPtDyo27ouokpdnVtID/AMtQ39waQ1FfS3Wu02dFd5lfltvj9J3ZfkGFzDBM9mz3WJQAMqEhSw3HhPhAcTBEQZ8qsTUOU2MWsoWq34gcGLOU9m3xiXBauk3rURaubSsBfCfyldIEER8I2qVOoJ2aGq06pgpuJu+zwG3jPxLT6rdq4RAMhtl3jePER6VEL1WZUiSditARx359pl2dsjH4thjLxBgs5bZyQY0idhBPltEUulLO3vHLdVXVXhBG3OM7sZWi2ME8sRqhiHUSY1MedRjgdB02m5m6PhKxKqo3nrLCRuO7Q46yr3cRbBVrHga2Vbu3Ph8YkMCSV22A95rOt8NOATnnfPpLBcnX0rwJDtiWaxZ+8ICbdlxcZ42B8SRMEtPg2HnvVPQFdvLPJGMfnGVyRl//AFFbE3cMqK9tC12PEtzUVBjeQSAfSvRl6VUdK/FMYJcxPU23tzJ2xmDrhu8vv8Q2taYaDMDfoRvxxV4s6aupjz2i/l9VoVF47yb7I/aAlrDrbxdu6wQhUuquoFegYkjdeAR0j5oKGC5A2jzgM+M7yezn7ScPZRWtI1xmEqJ0yD1MAx/e1WFNgc8+kpB3IxxIDGZ9czC3ibzIxsWFhbakrbLmYd2J3KyIUCTK7ATUg6VnIP1nVRnPSIu5fl937vcxNq6LRQFfDq1P+oyPgEFU25M+tSNpsQtjA95I0mtwnLGcFrIMVdtPjHRnSfFcLDpA31HUTwODUa2qx1MZyxLOrpxuY5fZzk+lTiWG7SqDyA2J+ZEewPnTHmBxkcSixCjdJ5jvcuBQWYwoBJJ4AFclcqbF5qb2L+9FSbdu4h9kDeEe5gmPMmoagA1moHDMDj8JfTswY8A7zsxnY1n/ABMLcS7abcS0Edd+h/Y+lZVPjIr/AMeoQqw22Gf79I5ZomJLVnInHYy9cRi7Ng3BpVFW5cUyDoUlipPOwCA+gpjz20+le8jGTkA+/H8ytk6rAg7bGWv2cwqXcYqlCLdi3rRTM6gVVWbqTHE77elYfhyeZaXbnn8ZpXk104B52lg1uzLhRCFEJw51hmuWXVPiI26Utq6TbUVEtocJYGMqrt3k7XLFtEUd5hretvOIAcCOTMNHWKR8L1HlallsOFO31l+qTrTzB6xT7N5rZw63b91y195VQBLb7sxJ2EsRz5HzrT8R0l2pZKaxhBuT29hKNPaidTsdzOnAZPcu2LmpFsWT41a4fG1zoSzdDJBMKN9hVVutrouUKxd+CBwF9MD/AHxJLS1iHbA5+snfs6z+R90umGSe7nqBMr7r09PathxkdY4MQ42MdsRZV1KsAykQQeDVJAIwZxWKnIiJatXMqxguKWbDXPCRMmOY35ZTuPMSPOknQUnIG01kY6uvpJ3E39r8svWLq5jgXHdt42I3Ck9T5o3UdDPntBwAepRLKHZx5Nkj8+7R2WuWMdhj3d9WAv2l6mJB/wASkBlLc8TFQO+GEmoKhqmOR2kp2lRr161jsvs6ok3GLIobTHILSSQSpETFXtWdmU/hFa7ekGqwfjIzPsZl+LAxLXWt3hsEs2wsEQRqmS3oykVP4G3zj58ysV21krgEfl+M5Mq7Q3mTuLrsUEuywo/DA31TGqYjcmS1VXXOlZGMsdsn39BJihHfqGwHYSNz3CObBF2FZL+qJPwXkFwADr5kn0A60uF8m/o9vzEYXFqA+8jcswjJ3eKJi0l9ULABmUgB1lTsQRMSYlY22loPnBMraoDKjvJ/OD9/x6pfxSm3pGm6inYQPDo6OTueR6mIqeOp8KfpKv8At1ZZd/Waszvd4/3LA/jJPdKxC6mjYxAgLsfEem+1WPq2K+UBiV16FQfOc5kXmvZO9gz+Ndt2tQ+FX1vHsomNueKjW4UHLQarzG+BSRHB8mxBwCYe3aXDYVPxLt6+YZz8ROhSW5ggEA7KOm9T4I9pZU3Q+QMn0mnJf+MVctsMq21XU97uoLhGUyFLat2P5jUmtRlCgGdFT0ubmxn0mXbXBrZWxl2Euu5JJddU7kgrqA2G5Zj5QDXCc4rUTtX/ACusMbMuwYtWrdpeEULPnA5+Z3p9RgYmUzFmLHvFDt7nRYjCWd2YjvI8z8Ke52J+XmasBCqXbYCCgk4EjLL4nL7a67Vp7Nw+ITq1EjgncDYGIBHNYdg0viVp6WYOo27fhNJfM0y/EoKnmc2Z2sFcsvfs67bAhTZ6FmmPSNidugiATVmmOuruFNuGHPV7D95x1oKF0yPaTnYLL2sYd8U6hDc2S4/ItgblRz4j7SAN6T8c1JaxalO3fHrJ6CnqPVjeWr2Jy8W8OrlSLl3xuzbsZJKz5eEjbpJ9aZ0lQSoYGCYauwtYRnYRhpqLQohCiEKIRN7S4QWO/u6v+cAAPI7gj+B+VYHiOmKMGHBOfr/uaOnfzAExxmVlmeWrlmLQx3tlxMMoJBHyiVMEERsYrYRz4jp2RT0uuB/faIjFD5YZBkQcXisdfURrIMhI/DX1IO0epkn14pjydJoKD29+5P8AfSc8y3UP+3aSWfYHcPbvB8VZUPeKKFGxABEbalkCOSPaCt4fqmXZ16a2OFycn898H9ZZqKQdwcsOY5dkO0y4u3DQLyjxL+ofqX0PUdD8q1XTpiEmcwwSXrbW7ihkbkfzB5BHnVZAIwZ1HZDlYrWcBicDItL96wxM9086kPO2k7g+x9huSuVsr/7fEeFlOo/7uxi12izIXJRMvtYdm6rbYOeu0KPpFLksRgrH6wle4sz9ZB28JeAIOu0h+Iurop+UEtU1qbg7CQsvQfdwx+k6bNllCMinSz6RiLqwBxJRPIDfVufUHarOoVYK7e/eU4a/IbfbgcRozfJrWBewXvaxfe33twwRp1kkjb4Y0nkbL13qh7AdQvoBn6yCAmlh34wJJ/azaZkULa2LooZWEtEkDSNzGoifUUuSW1WO+P1ltHStRJ7SHv4D7rlV63fUd5iWBVZ4K6dIH+WJLcbx5S+1a1Lud5ULHvt+EbCIuX4q5ZuK9uQ6eIFd49/LmOetVL/5CMMFA6Hkic/ZsSuIc6WGx7tRbJXqJg7mdyZP7V3rbq6pw01dBUfnOjPc9t3cSmIsrcBEMy3X7wFlIgCd9MAcmh2BbIEKq2CdBO3tGLGfaBbu4Y27y3brOo1gOLaTM7ES+0AevpU2tUjHTKV0rq2evaQHZLC4m47Lh3NtWA7y5GwAmBvuT6Aj14rlCOTtsJLU2VqB1bmWHlGR2rEsJe43xXH3Y+fsPb96dRAnEzLbms549Jwdru0y4VNKEG8w2H6R+o/yHWrVXMqxEzKnGFbvrypddpDIX/ERW5MEQWYHcTIB3+Ixm6vq1o8qslQNwcbEj8wM/jH6QKPicZ9vSMti3hxhicPaTEWdetkuXAvdbAfmUwAJJkzuSJmsOxtR9pAvco+MZA+9+EeUVeX8I6h6ekWsFlJx94m1at2LCRrJ2UDk7gSzHfaNhHHXde8aCnFthZjxnf8AL2iBXzn+BcCWfkeCXFYpGjvLNkyzMsW5ghVUdSCQd5gDpNYPh9DvZ5jDb9Zp3N5NXTnBPaWLW/MqFEIUQhRCFEJzZhgUvIUuLqU9P6HkGoPWrjDCSR2Q5WI2fZSt58RZvJ4Vtg22I3B3hgfrPtBrDD2aGwsvr+UeZFuqUd95WD5picNabCsGRyQVYCG0mdgeSDMgjjf5eg+xafU2rquR3Hv8vaIi561NY59Z3dksjYDvr2pbYYFLc6WuOsldiRMGYHU+nKnimvQ/4acE43b0Hf8AvaW6WhvvNnHp6zkxll+8N+yncXlux3SmSTp1SoH5gvxJxv6xTOk1HlKK3bqXpz1cY7YPt6GVXVdRLKMHPH9/SPHZXtYmJAR4S/8Ap6N6r/7efen2TG/aKRjioiRnhNdEMTyiESe2uYtfwIZE8P3kgN6KLic+pUn50leVK9RM1NGrJb0r6frMe2uVk4DDOl53QJbi3G2nSDO2+oAftWY1qHV4VdyJfUrBSr9jkmaczzXvMvwboGYrKweSbasvTfcj51VTka4n5Swoprf0Im4YMXUuY7NH1Np8FhNlQD4VO/JJ+HfqTvMbLVlR1MJn12FiK6yfpIX7NsvnEPcjZLcH1LmAPaA23tUtNkkmS13SihBzHPF9l8JcMtYUH/DKf+JFMNWp5ESF9gGAxmu12Swi/wDRHzZj/Fq55Sek79pt/wDIzbhuzmFttrSwgboTLR7apj5VIVqOBItc7DBMlBU5VFftR2tTDg27UPd+qofXzPp9amqZnQIqYLA3e6OYELfYPq0tJgAkF28yCBA4A36QMvV6tHvOiJK5HP7fX/UeppZUF2M+0mtFnFWLtzD2lZ3Ia7ZZoII1SyRw5n4uD5TIrLDX6S5K73IUfdYDO3ofUe3bO0bxXahZBnPIi49vXct4awQHdEt3iCNDMu5MjooHiI5Kkx1OvW3SjX3cAkrnkA/3b5xRjv5ackYPzj3kuRhR9zwzG65l3uOdCD4VJAXnoI3rBsezX39eAAP0mjQi6evqcy08my8WLKWgZCCJiJPJMdJJO1bVadChRM+x+ty3rO2pyEKIQohCiEKIQohI3P8AANessiGGjYn+BpXV6fzkx3EuotFbhjxK87U9nvvK4eyzC3fRIBIncJJBj8p0zInpWbo9W+jucOCV7j9xL7qhapdfWI1zMH1i1irlxLuHJCMo7yTxBBI8X6bk+U9DWydOvSbdMoKvyCcf0eoiwuLHpsOCv9/GdmVYRcFbbF31PeEkWbb/ABb9W9SOT0HqYpTVXPr7BpaT8I+8w/QfKW1KKVNr89hI/PsO33exirnhvXGaYGmR8StA4I8+YKzT2guUaizTV7ooGO+/cSjUITWth5Mlezvb10hMSC68Bx8Q9/1e/PvWo9XcROP+X5hbvrrtOrr6Hce45B9DVBGIYmnPswFjD3Lv6V2/zHYfuRVdjdKkiW0IHsAPEj8iwPeZdaw9+2VAYsQTpY+NmHG67HfrueKoqo+H44zqdSPNLVTozJVR8JaRQED7ADYBVc1kqg/6mfp+kZrJOkZu+P3kTkHZm7du3LLt3drDvqtELOsXDcPMjgADbin69OlV5tI32/KV36g21dKnnY/SLHbDMBdxPc2ASltu7tqPzONmb3LTv5RRYz3PvGNMqaarPePHZfJ/utgId7jHVcI6sensBA+XrWhWgRcTHutNrljJWpymeTRCcOZ5pasDVdcKOg6n2A3NSAJhgxCzvtjdv6kw6sltQSzDdyvEmPgG/Tz5qeFTHWef1kwueJw9m7WEfUl9XZ2HhKmIjooBktG+8zwBPOZ4m2sTD0EADn/ftHNKlL5D5zJvCr9zs9/Yui/YFwSBzoeFYN01BghB25aQJM5VjfbbfKuTofHPuOD9QTG1HkJlTlc/kZDY22pxTJl2tmuAqQsRBgkIei7btMRxtvWnpg506nW4+E5GeduCf2/OKWsquRSTvGjJ8r+5W0VbKtjLggkkM4J/KgAYADidp5O3GNrNY+scoh+DPA7x7SaRVHW0tHs12eTDKWJL3nHjdvrA8lmtPT6ZaRtzF9RqWuPsOBJumIvCiEKIQohCiEKIQohCiEiM4yVLrC6BF1B4SDE87H03I+dKarSrcp9cS6q9kHT2MrnOsrTEriEu2u7vKddtysOOkHqy7Dz524FZWm1V2gZQc47iN36ZLVDLj6esTceL2De3bxVlLwUTZLElY2+EgiV48LDbyFehWqrVKz0OVzzj9/f3mf5rIQLBnHEic7zi5iX1XCNtlVdgo9P605o9DXpE6a/qTyTKrr2tOTJHs3kwu2sRcKa3tqCluSszO/hIJ4MAHc0n4jrWptrrDYBO52P67S3T0BlZiMkdplhsvIK3cNfFtmCwpcqdbfkDD4jtMGIBWZmpDXMhK2oTgncDsP8Al7fv2nDpwcFTz2P6SVftVibMW8bhxcAIILDSZBkGRKNB32HMU1VZTeuamBEpZXrOGGIw4Ht1hH+IvbP+JZH1Wf3ipmthK9pJW8fhLrq4vW2dfh/E42j4SfInpS/2dA/mdO/rLPOs6OgHaSVvEAbq4B8wRVhXqGDKgSDmKeQ9mEwt97z3FYAfhFiJWZ1E9JiBI8zxNV109JJjN+pNqgYkxic/wyfFiLQ9AwJ+gk0xg+kVxIbHdvcMmyB7h9BpH1aD+1SFbGGJDXO1OMxMjD2gijlhvHu7Qo29Jqq66mjAsbc9v9Syupn+6MxXzTDMALrXlulyQxVixBEEAlgORxG2xqdGoFjFekjHr/f1nbKioByDOjsfi2t4kaQCWR1AJgE6SQCfIsoFLeLVCzTHPYg7fMCXaJ8WfOS+c5ZhryNiMNdS0yEa1khNXPgIHPlpBBjaKzNJqtVS66e9CwYbHG+PcfrneMW0I48ysgEfhmRNpHxbqtm2yFgBeuAMVJgFmYLKgSJgcnfrtoHo0dZa1s4+6Nth2G+8XLG1gqDnmPGUZbYsnucJ31zEXBpJabZMSTvpGhRBMT5cmsDUai/XOFxhfSaNGnWgdbyxOyPZwYW2S5D3nMs+7ETHhDN4tIj6kmtTT0Cpcd4vqL/MbbiMNXxeFEIUQhRCFEIUQhRCFEIUQhRCR+d5WMRaKaih6MOR/UHyqjUadbl6Wl1NxqbqERs/y8WLdm3ikW6gMTpldO/nuGC8deN+axXpu0tvWp57iPKtepyAPpEjP+wVwXHOFKvb06ghbxx5CRDDiCTO455OzofHa3Tpu2Pr2mZbpHXdeJyZbntu1fF5g9tlt6GsqvhaBpG5aVGw2IMEcmalqPD7LqPJUhgW6uoncZ52x+8sr1Cq/WdtsYnvY/C6r1zF3RptWw1yY8Orfjzjf5gUeK29NS6Ws5ZsD3xDSplzaeBkzkwuJfFNcFwkWTdF24RO0+BVH1ge0/lq22uvRovl46+npH6kyKM1xPV93Of9Td2iw1mxi7wa3Kd2DbtqSo1EIOV4Ahz61zQ236jSIUbByck7+v8AqFyVpaQRtjYTb2gyrDWH0TcVu57weIEapI0wVneDvNR0Gt1d69exHV08dvXadvopQ4OQcZmGP7O2bZtA3LkXE1zoUhF8O7eIbDUOKlR4lfarnpX4Tjk7n22PpIvpEUgEncZ4nIuRqtkXmFx0Nxlm0B4VUkamkHmDA2G3O9XHxBjb5S9KkAH4u5PbtKxpwF6jnGcbSIzBFW46o2pAx0nzWdj9K0aWZq1LjB7iLuqhiFO0Yc1tfc7eFNsLLprcsobWfCdJJB8IBiBHPnWJpW+3WXC0nY4G+MD1+cdsH2cJ099z/EmgbeHxeGvWhotYpIZeFBIUgx03K7e9Z2LdTpban3as5B77RoBa7FZfut2i72xsqlxba2yndgoDuQyfGpBPXxMCOm1a/g9jPUbC3V1b/I8Hb8Inq1VWwBjEhcsuMt22yLqcMCqgEyQdhA3PsK0r1FlbIxwDtFqyUYMI15b2S1armN7yws7W7duD03+EqojaIJPWOuNqvFV0+K6fiOOSf37xyrSvccnYekc8lym+6W7eCZkw4/6jKqjYwdigZ2JB3HXkishaLtW/XcOff/cf/wAVC4PI7R8ybs7YwxZra+NuXY6mPX5D0EVsU6dKhhRErb3sGGO0lqulMKIQohCiEKIQohCiEKIQohCiEKIQohML1pWBVlDA8giR9DXCAeZ0EjcRax/ZEd6L1lyhA+CJQiIgRGkH5xtttFZ2o8OSwHp2z+sbTWEJ0MMj1ixmmBN5LlnF2LioCSjlfhJ/S8RudxvB3HECs5DqtHhxnbnnEvsqptA6SMmKz9kiLJfB4hjPhuW3iCPWBB2MwV/etVfF6XcDUJ8jE20lleymQ+YYPE4UWrb22tqGLB7LE65AmSCRqgbcbTtTyNp9SzOrhiRjDdpRl6wFxjHpMM9zOzisRbuSyLAD6hMaWJ20zMgx04o0Wku0unevAJOcYPqPf0kr7a7bA2fnMO2GNTEYnXacMpUKJlYjz1ARuTvxU/CqX02n6LFwck+sjrHWyzKnMns9x4uabNq9YNtrIR2N1BpYMpnc6jsOBzPpWToqDVm2xG6gxIGDvsY5c/VhFIwRjOR6yMynHvh1Bw9+2VNxw1u66rsCNLiYIleYPPQ07qqE1LHzqznAIIBO5HH0Morc1D4GBGeDtIXtJft3MTcayPATtAiTAkgepk1o+H12V6dVs5EW1DK1hK8ToOdi5h0sX0Ld2fw3RgGA4gyCCI/gPKqfsLVXm+lgOrkEZHz2k/PVqxW447ib8UmKvPZ02LiKihbQZDpUCIJZ1CngEk7bVFE02nrfrcEtu2/OfYQLvaw6RxxJleyF5mF3GX1upEkW7pYn0krAHt8vOkLPF9Pp16NMu/y2/mXjTW2t/kMnsoyu0xZsvwrrcVYLap2P+JnI3j3pB7dXqzgnKxxNPVpz/k2jZk3ZBntg49muNqnQGAVR0B0Aaj18ulM0eHVr8TDeV2awq2Kdh6xvsWVRQqqFUCAAIAHpWiAAMCJEknJ5myuzkKIQohCiEKIQohCiEKIQohCiEKIQohCiEKIQohMblsMCGAIOxBEgiuEA8wBxxITGdl7JRltKLLH8yD+Incb+lKXaGqwYxiNJq7A2WOfnF/FdnMXbtBbbreIbaIQqOnxGDHuIpB/DHVupT+0ZXU0ux6hj85HZzlQUrdxGCD3Ts0Ww4Ye4kT5dRxxUU+20HpBOJAU0Wk8fXaQmOyPLrd3VcsuFcTo1OujrOmdQ9vp631+K61fhbG3tvIDw9HGV/WasX2WwC+AtcQt8NzXsPRgRA9/lseer4zqsHKjPpI/9PDDIMxs9nsuKlCzi4B8evmATI2C/KPrzXW8Z1XT1BROnw3BE9y7JcBc/BXDO79LiNcYnbqAYH0j24qB8S1tg+DGflJv4clf3j+cncqyp3/Dt5eiqu4drS2ipHBkjxGeog1ArrLxuxEm1Wnpwcj6byZyvs3i2LC/dC2yD4f8AmGffp8yfYVJPDS33/wApF9TUMGsbyTyfsTYsszMTeZhHjAgddhHPqZp2vR1pzv8AOVW6x7BgbfKMGGwqW1020VFHRQFH0FNKoUYEVZixyTN1dnIUQhRCFEIUQhRCFEIUQhRCFEIUQhRCFEIUQhRCFEIUQhRCFEIUQhRCYPaBIJAJHBI4rhAM7kzQ+X2mfWbaF/1FQW+sTXOhc5xOh2AwCcT21gLasWW2iseWCgE/MCaAqjcCBZjsTN6WwOAB7V3EjmZV2EKIQohCiEKIQohCiEKIQohCiEKIQohCiEKIQohCiEKIQohCiEKIQohCiEKIQohCiEKIQohCiEKIQohCiEKIQohCiEKIQohCiEKIQohCiEKIQohP/9k=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5575" y="6583417"/>
            <a:ext cx="9144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prstClr val="white"/>
                </a:solidFill>
              </a:rPr>
              <a:t>Copyright © 2016 Human Engineering Research Laboratories</a:t>
            </a:r>
          </a:p>
        </p:txBody>
      </p:sp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6629400" y="0"/>
            <a:ext cx="2514600" cy="14196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60375" y="1537930"/>
            <a:ext cx="8378825" cy="4431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US" sz="2800" b="1" dirty="0">
                <a:solidFill>
                  <a:srgbClr val="002060"/>
                </a:solidFill>
              </a:rPr>
              <a:t>Development and Evaluation of Powered Personal Transfer System (PPTS) Focus Group</a:t>
            </a:r>
            <a:br>
              <a:rPr lang="en-US" sz="2800" b="1" kern="1400" dirty="0">
                <a:solidFill>
                  <a:srgbClr val="B9912B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Minion Pro" pitchFamily="18" charset="0"/>
                <a:cs typeface="Narkisim" panose="020E0502050101010101" pitchFamily="34" charset="-79"/>
              </a:rPr>
            </a:br>
            <a:endParaRPr lang="en-US" sz="2800" b="1" kern="1400" dirty="0">
              <a:solidFill>
                <a:srgbClr val="B9912B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Minion Pro" pitchFamily="18" charset="0"/>
              <a:cs typeface="Narkisim" panose="020E0502050101010101" pitchFamily="34" charset="-79"/>
            </a:endParaRPr>
          </a:p>
          <a:p>
            <a:pPr algn="ctr">
              <a:spcAft>
                <a:spcPts val="600"/>
              </a:spcAft>
            </a:pPr>
            <a:endParaRPr lang="en-US" sz="2800" b="1" kern="1400" dirty="0">
              <a:solidFill>
                <a:srgbClr val="B9912B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Minion Pro" pitchFamily="18" charset="0"/>
              <a:cs typeface="Narkisim" panose="020E0502050101010101" pitchFamily="34" charset="-79"/>
            </a:endParaRPr>
          </a:p>
          <a:p>
            <a:pPr algn="ctr">
              <a:spcAft>
                <a:spcPts val="600"/>
              </a:spcAft>
            </a:pPr>
            <a:endParaRPr lang="en-US" sz="2800" b="1" kern="1400" dirty="0">
              <a:solidFill>
                <a:srgbClr val="B9912B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Minion Pro" pitchFamily="18" charset="0"/>
              <a:cs typeface="Narkisim" panose="020E0502050101010101" pitchFamily="34" charset="-79"/>
            </a:endParaRPr>
          </a:p>
          <a:p>
            <a:pPr algn="ctr">
              <a:spcAft>
                <a:spcPts val="600"/>
              </a:spcAft>
            </a:pPr>
            <a:endParaRPr lang="en-US" sz="2800" b="1" kern="1400" dirty="0">
              <a:solidFill>
                <a:srgbClr val="B9912B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Minion Pro" pitchFamily="18" charset="0"/>
              <a:cs typeface="Narkisim" panose="020E0502050101010101" pitchFamily="34" charset="-79"/>
            </a:endParaRPr>
          </a:p>
          <a:p>
            <a:pPr algn="ctr">
              <a:spcAft>
                <a:spcPts val="600"/>
              </a:spcAft>
            </a:pPr>
            <a:endParaRPr lang="en-US" sz="2800" b="1" kern="1400" dirty="0">
              <a:solidFill>
                <a:srgbClr val="B9912B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Minion Pro" pitchFamily="18" charset="0"/>
              <a:cs typeface="Narkisim" panose="020E0502050101010101" pitchFamily="34" charset="-79"/>
            </a:endParaRPr>
          </a:p>
          <a:p>
            <a:pPr algn="ctr">
              <a:spcAft>
                <a:spcPts val="600"/>
              </a:spcAft>
            </a:pPr>
            <a:r>
              <a:rPr lang="en-US" sz="2800" b="1" kern="1400" dirty="0">
                <a:solidFill>
                  <a:srgbClr val="002060"/>
                </a:solidFill>
                <a:latin typeface="Minion Pro" pitchFamily="18" charset="0"/>
              </a:rPr>
              <a:t> </a:t>
            </a:r>
          </a:p>
          <a:p>
            <a:pPr algn="ctr">
              <a:spcAft>
                <a:spcPts val="600"/>
              </a:spcAft>
            </a:pPr>
            <a:r>
              <a:rPr lang="en-US" sz="2800" b="1" dirty="0">
                <a:solidFill>
                  <a:srgbClr val="002060"/>
                </a:solidFill>
              </a:rPr>
              <a:t> </a:t>
            </a:r>
            <a:endParaRPr lang="en-US" b="1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82588" y="6033930"/>
            <a:ext cx="8378825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  <a:latin typeface="Minion Pro" pitchFamily="18" charset="0"/>
              </a:rPr>
              <a:t> </a:t>
            </a:r>
            <a:r>
              <a:rPr lang="en-US" sz="2000" b="1" u="sng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9412479-6E77-BD41-A4A5-CD45F2A6161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6700"/>
          <a:stretch/>
        </p:blipFill>
        <p:spPr>
          <a:xfrm>
            <a:off x="2820987" y="2895600"/>
            <a:ext cx="3657600" cy="2526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71383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NHBedNewControlAudio" descr="NHBedNewControlAudio">
            <a:hlinkClick r:id="" action="ppaction://media"/>
            <a:extLst>
              <a:ext uri="{FF2B5EF4-FFF2-40B4-BE49-F238E27FC236}">
                <a16:creationId xmlns:a16="http://schemas.microsoft.com/office/drawing/2014/main" id="{DED4249B-40B1-164F-83E0-077E92396C1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-22225" y="1027212"/>
            <a:ext cx="9144000" cy="513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87674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3622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2C7E7FFA-A2A5-5748-9494-A1FD7DD82BA9}"/>
              </a:ext>
            </a:extLst>
          </p:cNvPr>
          <p:cNvSpPr/>
          <p:nvPr/>
        </p:nvSpPr>
        <p:spPr>
          <a:xfrm>
            <a:off x="76200" y="1318123"/>
            <a:ext cx="9144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Controller Options: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12" name="Picture 11" descr="A picture containing electronics&#10;&#10;Description automatically generated">
            <a:extLst>
              <a:ext uri="{FF2B5EF4-FFF2-40B4-BE49-F238E27FC236}">
                <a16:creationId xmlns:a16="http://schemas.microsoft.com/office/drawing/2014/main" id="{A5E633B3-31C9-B44B-A8E9-CC8473A3117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6736" y="1007083"/>
            <a:ext cx="5601064" cy="539232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0804FB4-888C-6B42-AAA3-2B6F3CDBEEB4}"/>
              </a:ext>
            </a:extLst>
          </p:cNvPr>
          <p:cNvSpPr txBox="1"/>
          <p:nvPr/>
        </p:nvSpPr>
        <p:spPr>
          <a:xfrm>
            <a:off x="228600" y="2072715"/>
            <a:ext cx="323813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dirty="0"/>
              <a:t>Primary User Interfac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Larger controll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Backligh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ontains all necessary functions to operate be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C5FE53-D4E7-4D42-9099-0C6BC7363974}"/>
              </a:ext>
            </a:extLst>
          </p:cNvPr>
          <p:cNvSpPr txBox="1"/>
          <p:nvPr/>
        </p:nvSpPr>
        <p:spPr>
          <a:xfrm>
            <a:off x="228600" y="4032787"/>
            <a:ext cx="308573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. Penda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maller controll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Limited number of commonly used func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lows user to select functions while in bed</a:t>
            </a:r>
          </a:p>
        </p:txBody>
      </p:sp>
    </p:spTree>
    <p:extLst>
      <p:ext uri="{BB962C8B-B14F-4D97-AF65-F5344CB8AC3E}">
        <p14:creationId xmlns:p14="http://schemas.microsoft.com/office/powerpoint/2010/main" val="358176828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2310A30-0623-E74D-B691-4AE7599CE0E5}"/>
              </a:ext>
            </a:extLst>
          </p:cNvPr>
          <p:cNvSpPr txBox="1"/>
          <p:nvPr/>
        </p:nvSpPr>
        <p:spPr>
          <a:xfrm>
            <a:off x="76200" y="2146341"/>
            <a:ext cx="6477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omes with features that are standard in hospital bed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/>
              <a:t>Head up/dow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/>
              <a:t>Feet up/dow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/>
              <a:t>Elevate/Lower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588EF79-62FE-F247-B7E4-DF081BF9AA03}"/>
              </a:ext>
            </a:extLst>
          </p:cNvPr>
          <p:cNvSpPr/>
          <p:nvPr/>
        </p:nvSpPr>
        <p:spPr>
          <a:xfrm>
            <a:off x="76200" y="1318123"/>
            <a:ext cx="9144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Bed Functionality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10" name="Picture 9" descr="A picture containing furniture, blue&#10;&#10;Description automatically generated">
            <a:extLst>
              <a:ext uri="{FF2B5EF4-FFF2-40B4-BE49-F238E27FC236}">
                <a16:creationId xmlns:a16="http://schemas.microsoft.com/office/drawing/2014/main" id="{EF66B400-BD7B-E04D-A1D1-445803FCC7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2341" y="3019769"/>
            <a:ext cx="5098586" cy="346123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152BF84-14B8-4B4D-BB69-82BCCFCD86A8}"/>
              </a:ext>
            </a:extLst>
          </p:cNvPr>
          <p:cNvSpPr txBox="1"/>
          <p:nvPr/>
        </p:nvSpPr>
        <p:spPr>
          <a:xfrm>
            <a:off x="60419" y="4007119"/>
            <a:ext cx="33419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Unique features include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/>
              <a:t>Transfer to/from b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/>
              <a:t>Sheet up/down</a:t>
            </a:r>
          </a:p>
        </p:txBody>
      </p:sp>
    </p:spTree>
    <p:extLst>
      <p:ext uri="{BB962C8B-B14F-4D97-AF65-F5344CB8AC3E}">
        <p14:creationId xmlns:p14="http://schemas.microsoft.com/office/powerpoint/2010/main" val="40870582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2310A30-0623-E74D-B691-4AE7599CE0E5}"/>
              </a:ext>
            </a:extLst>
          </p:cNvPr>
          <p:cNvSpPr txBox="1"/>
          <p:nvPr/>
        </p:nvSpPr>
        <p:spPr>
          <a:xfrm>
            <a:off x="80530" y="2157504"/>
            <a:ext cx="44637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roup 2 power wheelchair base with custom backrest and seat to work with bed </a:t>
            </a:r>
          </a:p>
        </p:txBody>
      </p:sp>
      <p:pic>
        <p:nvPicPr>
          <p:cNvPr id="9" name="Picture 8" descr="A picture containing indoor, sport, exercise device, cluttered&#10;&#10;Description automatically generated">
            <a:extLst>
              <a:ext uri="{FF2B5EF4-FFF2-40B4-BE49-F238E27FC236}">
                <a16:creationId xmlns:a16="http://schemas.microsoft.com/office/drawing/2014/main" id="{CD3D1D85-E0CA-554A-912C-8391B412AA2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54" t="702" r="7271"/>
          <a:stretch/>
        </p:blipFill>
        <p:spPr>
          <a:xfrm rot="5400000">
            <a:off x="4546168" y="1555736"/>
            <a:ext cx="4714872" cy="4278168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D6ACD7CC-4C6F-3947-9EF1-D76468925859}"/>
              </a:ext>
            </a:extLst>
          </p:cNvPr>
          <p:cNvSpPr/>
          <p:nvPr/>
        </p:nvSpPr>
        <p:spPr>
          <a:xfrm>
            <a:off x="76200" y="1318123"/>
            <a:ext cx="9144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Power Wheelchair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40125263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1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dirty="0"/>
          </a:p>
          <a:p>
            <a:pPr algn="ctr" fontAlgn="base"/>
            <a:r>
              <a:rPr lang="en-US" sz="2400" dirty="0"/>
              <a:t>Overall, what do you think of the system?</a:t>
            </a:r>
          </a:p>
          <a:p>
            <a:pPr algn="ctr" fontAlgn="base"/>
            <a:endParaRPr lang="en-US" sz="24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344081685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2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dirty="0"/>
          </a:p>
          <a:p>
            <a:pPr algn="ctr" fontAlgn="base"/>
            <a:r>
              <a:rPr lang="en-US" sz="2400" dirty="0"/>
              <a:t>What features do you like best and why?</a:t>
            </a:r>
          </a:p>
          <a:p>
            <a:pPr algn="ctr" fontAlgn="base"/>
            <a:endParaRPr lang="en-US" sz="24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415774216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3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dirty="0"/>
          </a:p>
          <a:p>
            <a:pPr algn="ctr" fontAlgn="base"/>
            <a:r>
              <a:rPr lang="en-US" sz="2400" dirty="0"/>
              <a:t>What features do you like least and why?</a:t>
            </a:r>
          </a:p>
          <a:p>
            <a:pPr algn="ctr" fontAlgn="base"/>
            <a:endParaRPr lang="en-US" sz="24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221067602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6"/>
            <a:ext cx="7296665" cy="2341465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4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/>
            <a:r>
              <a:rPr lang="en-US" sz="2400" dirty="0"/>
              <a:t>Is there anything you would suggest changing on the PPTS- EPW with regards to the following categories: handling, maneuverability, seating, appearance, or anything else?</a:t>
            </a:r>
          </a:p>
          <a:p>
            <a:pPr algn="ctr" fontAlgn="base"/>
            <a:r>
              <a:rPr lang="en-US" sz="2400" dirty="0"/>
              <a:t>Do you feel that any features are missing from the system?</a:t>
            </a:r>
          </a:p>
          <a:p>
            <a:pPr algn="ctr" fontAlgn="base"/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02941539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5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dirty="0"/>
          </a:p>
          <a:p>
            <a:pPr algn="ctr" fontAlgn="base"/>
            <a:r>
              <a:rPr lang="en-US" sz="2400" dirty="0"/>
              <a:t>Do you think you would be able to use a device like this? Does the system seem user friendly or is it too complicated?</a:t>
            </a:r>
          </a:p>
          <a:p>
            <a:pPr algn="ctr" fontAlgn="base"/>
            <a:endParaRPr lang="en-US" sz="24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68237007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6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/>
            <a:endParaRPr lang="en-US" sz="2400" dirty="0"/>
          </a:p>
          <a:p>
            <a:pPr algn="ctr" fontAlgn="base"/>
            <a:r>
              <a:rPr lang="en-US" sz="2400" dirty="0"/>
              <a:t>Who would most benefit from this technology?</a:t>
            </a:r>
          </a:p>
        </p:txBody>
      </p:sp>
    </p:spTree>
    <p:extLst>
      <p:ext uri="{BB962C8B-B14F-4D97-AF65-F5344CB8AC3E}">
        <p14:creationId xmlns:p14="http://schemas.microsoft.com/office/powerpoint/2010/main" val="39953991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140575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Introduction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0AB2D17-40A5-9744-9378-A8310D68E7DF}"/>
              </a:ext>
            </a:extLst>
          </p:cNvPr>
          <p:cNvSpPr txBox="1"/>
          <p:nvPr/>
        </p:nvSpPr>
        <p:spPr>
          <a:xfrm>
            <a:off x="533400" y="3975649"/>
            <a:ext cx="83058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8926727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6"/>
            <a:ext cx="7296665" cy="1972133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7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/>
            <a:r>
              <a:rPr lang="en-US" sz="2400" dirty="0"/>
              <a:t>Would you feel comfortable with a computer controlling your transfer? </a:t>
            </a:r>
          </a:p>
          <a:p>
            <a:pPr algn="ctr" fontAlgn="base"/>
            <a:r>
              <a:rPr lang="en-US" sz="2400" dirty="0"/>
              <a:t>If you are a wheeled mobility device user, would you feel comfortable using this with a caregiver? Would you feel comfortable using this without a caregiver?</a:t>
            </a:r>
          </a:p>
        </p:txBody>
      </p:sp>
    </p:spTree>
    <p:extLst>
      <p:ext uri="{BB962C8B-B14F-4D97-AF65-F5344CB8AC3E}">
        <p14:creationId xmlns:p14="http://schemas.microsoft.com/office/powerpoint/2010/main" val="302427579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8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/>
            <a:endParaRPr lang="en-US" sz="2400" dirty="0"/>
          </a:p>
          <a:p>
            <a:pPr algn="ctr" fontAlgn="base"/>
            <a:r>
              <a:rPr lang="en-US" sz="2400" dirty="0"/>
              <a:t>Do you think this system would make you feel safer while transferring? Would this system make your life easier?</a:t>
            </a:r>
          </a:p>
        </p:txBody>
      </p:sp>
    </p:spTree>
    <p:extLst>
      <p:ext uri="{BB962C8B-B14F-4D97-AF65-F5344CB8AC3E}">
        <p14:creationId xmlns:p14="http://schemas.microsoft.com/office/powerpoint/2010/main" val="405862868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9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/>
            <a:endParaRPr lang="en-US" sz="2400" dirty="0"/>
          </a:p>
          <a:p>
            <a:pPr algn="ctr" fontAlgn="base"/>
            <a:r>
              <a:rPr lang="en-US" sz="2400" dirty="0"/>
              <a:t>Would you use this system or recommend it to other wheeled mobility device </a:t>
            </a:r>
            <a:r>
              <a:rPr lang="en-US" sz="2400"/>
              <a:t>users? Do </a:t>
            </a:r>
            <a:r>
              <a:rPr lang="en-US" sz="2400" dirty="0"/>
              <a:t>you think any stigmas would be attached to using a device like this? </a:t>
            </a:r>
          </a:p>
        </p:txBody>
      </p:sp>
    </p:spTree>
    <p:extLst>
      <p:ext uri="{BB962C8B-B14F-4D97-AF65-F5344CB8AC3E}">
        <p14:creationId xmlns:p14="http://schemas.microsoft.com/office/powerpoint/2010/main" val="333535028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90600" y="2068837"/>
            <a:ext cx="7296665" cy="1692452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46" y="6458158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Discussion Question 10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990600" y="2101978"/>
            <a:ext cx="7162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/>
            <a:endParaRPr lang="en-US" sz="2400" dirty="0"/>
          </a:p>
          <a:p>
            <a:pPr algn="ctr" fontAlgn="base"/>
            <a:r>
              <a:rPr lang="en-US" sz="2400" dirty="0"/>
              <a:t>Do you have any other thoughts you would like to share?</a:t>
            </a:r>
          </a:p>
        </p:txBody>
      </p:sp>
    </p:spTree>
    <p:extLst>
      <p:ext uri="{BB962C8B-B14F-4D97-AF65-F5344CB8AC3E}">
        <p14:creationId xmlns:p14="http://schemas.microsoft.com/office/powerpoint/2010/main" val="176046855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911759" y="2672529"/>
            <a:ext cx="7391400" cy="2122164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21259" y="3326822"/>
            <a:ext cx="7772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Questions?</a:t>
            </a:r>
            <a:endParaRPr lang="en-US" sz="48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4149022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B6C2539-3FBE-5640-85AE-218F1076EA76}"/>
              </a:ext>
            </a:extLst>
          </p:cNvPr>
          <p:cNvSpPr/>
          <p:nvPr/>
        </p:nvSpPr>
        <p:spPr>
          <a:xfrm>
            <a:off x="829426" y="1744412"/>
            <a:ext cx="7391400" cy="2122164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580769" y="2020664"/>
            <a:ext cx="77724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THANK YOU FOR PARTICIPATING!</a:t>
            </a:r>
            <a:endParaRPr lang="en-US" sz="48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711439" y="4207254"/>
            <a:ext cx="76417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/>
            <a:r>
              <a:rPr lang="en-US" sz="2400" dirty="0"/>
              <a:t>You will receive $25 delivered by direct deposit (estimated time- one week) or a Direct Express debit card (estimated time- 4 to 6 weeks)</a:t>
            </a:r>
            <a:endParaRPr lang="en-US" sz="24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4618790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7" descr="data:image/jpeg;base64,/9j/4AAQSkZJRgABAQAAAQABAAD/2wCEAAkGBxQTEhUUExMWFhUXFyAaGRgYGB8ZHBwbHxwYGh8hICAdHCggHiAmGxobIjEhJSorLi4uHyAzODMsNygtMCwBCgoKDg0OGxAQGywmICYsNC80LDAsLCw0NywsLDQsLC80LCwsLCwsLCwsLCwsLCwsLCwsLCwsLCwsLCwsLCwsLP/AABEIAOEA4QMBEQACEQEDEQH/xAAbAAACAgMBAAAAAAAAAAAAAAAABgUHAgMEAf/EAEIQAAIBAgUBBgMGBAQFBAMBAAECEQADBAUSITFBBhMiUWFxMoGRBxQjQlKhscHR8GJygpIkM0OissLS4eJTY/EV/8QAGgEAAgMBAQAAAAAAAAAAAAAAAAQCAwUBBv/EADcRAAICAQMCBAMIAgEEAwEAAAECAAMRBCExEkEFE1FhInGBFDKRobHB0fAj4UIVM1LxYqKycv/aAAwDAQACEQMRAD8AvGiEKIQohCiEKIQohCiEKIQohCiE8JohOXFZlatiXdQPel31VScsJJUZuBOLE9pLCCWJjz0mB6k9BSw8UoOy5J9MS0aaw9ppudqrIAJnSfzSNPpuD+9QHitZ2wcyQ0rmZntLaABYMJ+Y95HShfFqSODn0xD7K83tn1oEBiROwkbfXipr4pQw7/hI/Z7PSbkzeySB3gBPAOx29KuTXUOMhhIGpx2nWlwESCCD1FMhgwyJWdpnUoQohCiEKIQohCiEKIQohCiEKIQohCiEKIQohCiEKIQohCiEKITkv5hbXlvpvStutorOGb9/0k1rZuBFrMe2ttZUk2z0LKf2O6z86QbxC23ahf5jS6Qjdoj5p9oHKsdQPVTBj1EkfvXa/DtVf8RYj5mWM+noYZ3PtIS12qxDjTat3Li8HYmPnvHzP0phvB6VGbbAG/vb+JE60dX+NCZGY/N8VaPduugFQQhOrY8Hn+Ee007pvDdHanUp6u2eJTZrr0f7oHtPcL97NhrwZDZB8UsNm2Hw8g7jbrPrUbKtCLVoKnq7e/vmcTVarp83IxC1jsUFQd4jC98C6wN5jiQF3232munR6MlvhI6eTOrq9QpB2OeJ3Ni8eim3ctFlXcrE6R/oJge9UDTeHWkNW+M7fP8AESQ1OprJLLmYDtbd0BLynkFW4MdIJ3+c11vBai2aXHoQf9TtfiGN3T8P9yayvt0oKs5K9HHn5MI4bzjn6Qld4NqE+Gs59MbSxNVQ65JwY8Zd2rJcJ3gcMAUbofQkcz50r9u1NS/GOOROtpVZepYx4XPrTSDKlfiBHHr7etaKeJUtjO0VfTuslAa0JRPaIQohCiEKIQohCiEKIQohCiEKIQohCiEKIQohOfF41LfxECl79SlIy0mqFuIp592t7uYZAB/iIP7CKyH11156a8j6R2vSbZaVlmvax7mvuEYBdyVLQB5kAxHuBWjp/CACp1DDft3PtIWaxQpFQJPr2i0l65iLiWy5JdwoniWIEmOYmtnyaNKjOi8DP4RFr7byEY7Sd+74e1jDhLllWtkqmslhc1MAQ0gwASeAAI/fNNmot0n2pHPVucbY27Y+Xf1l4SpbfKZduM98yYweXRbxuCuO7KgV0PLaSNQgExIKjbYSfWs67Ulno1aAAnY/PMYrrwrVE7CJWc3EN1u7P4X/AEx+lW8en0hmYR0r0ujVxUPMGG7/AD4zMy7HXtx2k12HxCs13C3PgvoQP8wB/lP+0VneNUsoTUJyh/KMaJgS1R4M5cIi3MfZtqZS26Ip8xb3J/1MGb/VVtrGvQPY2xYEn5t2+gwJxQGvVR22/CSXafEIbt1rOo39bI8wYtrZ0tAHC+Ikk9V9KS8NqYVIluOjGR8y3f3447S/UuOolOf2xN2WZjc+44m+7SSVt2xyqwFUaVOw+L9qjqdMn26qhB6k+pySd4V2saHdvkJzZbhbWJTEX7toBERYCeA94E8UafDud9weRVuput0r1UVvuxOc7jBO3Pp85GtEuDOw2Ej3wLIbQs3HR3uFe7YwUcaYkrsZLDoPXg04L1dXNqgqBnqHcH2Mo6GXARue0m7PaXEYe+v3q0QTs54lfMAbGOdj/GsxvCtNqaidO/yHvHPtligJYuPeOnZ/tJ8YtOHVfGg1bFOq+n8vlFZvmajSMvVn0MZemu1Qykbx4yzNkvBSpgsJAPUVr6fWJccDY+kz7KmTmSFNyqFEIUQhRCFEIUQhRCFEIUQhRCFEIUQkRm+dW7YI7xVbzJG371m6vXivKJktL6qC+8q/tR24jwowYnyEfxJpfR+GW6puuwkD3jVtlemA7n0ihIuPbv4ltVt2KsqN8HhldUcSTMDeA3ERWyqeUrU6cYYDOT333x/eYm9psYPYfhPYdpLXLve4AXbAFtrMrdtpsjKwgkrw20GTP5vKlFQU6/y7viD4Kk8g/Pt6bSbN1UdabY5ETbF0qwZTBUgg+RG4/evRMgdSp4MzlbpIIjDm2cYfEXLd9u8t3VjWqqGVoMiGLCPKSDtHlvj6bR6jTo1K4KnOCTjGfbvHLbq7GDnIPpib8JmONu37t+xYJa4InSSFURABJC9Buf2mrR4VT5CUvnC7+m/r/ErOtYWM47zC32IxbmWW0k9JAH0QED5VooVVekfzFWck5ndh/s/vqQwvorDcFdUg+h2oZlYYYbTgcg5E2YbsNibR1WsSqtESNS7fLpVdi1WL0uMj3EktrKcjmY4zs7mOl11W3DjxFdIZuDuxRT+9UrpNOrKwHHG5x+GcSw6mwgg95H5gmKt4X7tcwhRA2oMknff4jLAzPmOlRTQKNT9oDknGMHH5SR1INXl4m/Ls6tphrdqxc7txdDubkqHAMkBlkAbKN42FZ+o0Nj6lrbl6l6cDG+PocRqq9BWFQ75zvtOvIMsW3euYu9cDpbBPeD4WuNOor+oCYB6k+lK+Ial3pXS1rgnt3wPX58/SW0U4sNrHP6Z9vlDtU9uxbvWXZrt684uyRCoJgRv0Cldv4VLwuuy+1LUAVEHTj1+c5qiqKVY5J3i5l+Gv20OJSURdtR21SQsD9Q8+m3nWvqLdPaw0z7k9vTH6ROkWV/5V7esa8g7Vq9nu2JS8j6rcHY7yRPPnt5H3rB13hbUOLKiSO/rNPT6gahyGwMyz8pz7xKrmVddSN9JB+RkfOq9D4hylx47yq7T43WMaMCAQZB4NbQOd4nPa7CFEIUQhRCFEIUQhRCFEIUQkJnubd2JVlAHJJj+prJ12sK4So7xrT0dZ3EqXtJ2pu33NmzHBLMDAA3kkkCAOT0FT0Xh6qo1GoJ549ZbdcK/8dY39fSQuUYm1hboB7q9bcQXKGVkeTbhZIMx4hv6Vo6mq3WVHHUjL2yMH8O/t2MUrZKn3wQe8kjisAxuW7tpsM5GhwviSeQRp22O4MDb0JpIUeIKFsrcOBuPX3G/4ES4tpzlWHT+kgsozJ8K91LYW6XGgR4kbfnSN224EjkzWtqNIusRC+Vxv7/LPaKV3eSWHP6SVynsNeunXfIsqfyqo1fIDwr/e1O5CjAOfz/OKFi0css7M4axuloFv1P4m/fYfICoFyZyTNRhMgB1pTWWCuliWxtz7y+hSzjbMwBrF0nitmouRHIUd/ePXaRa0Zl3MzitzVWdFTMDg42PvEKU6nAxmYqax9L4q+otRCAvr7/L6x23RrShbn0nsV6DiZkjMzyDD357y0C36h4W+o/nNSDkQxFDNOxN60H+63C6MIa2TpJH/AIt84jpXWFbkFhuJNbHUc7SKx+bC4+rE2f8AiLahAjSEaGnxj4gYJ2mD+xzk0D0ApU2EYkn1G3bt+8cOoSzDONx+clO1N0pgrKEMGuuXKsQSAN9IgAQNSgADgCs/wxA2sdtsIMZ4+u/f1jGpJFIX1MjmyS2uAuXG/wCdbuAGPyz3YKHzgGfQyOhpoa+xtcta/cYfjzv9ZT9nUUFj94TuyftNcsfd7WIUgKwKXOfw28zMEAE7g8bdKW1fhteo6rtOR3yPcS2nU+WOi0HfvLQybPO7Ny28G2jbN+lW3+YBn5e1Z2i17VhanG36S+/TdWHXkxvBr0Ez4UQhRCFEIUQhRCFEIUQkPnmarbBSdyu8cgegFZmv1hr/AMajcj8IxRSXOZS3arO/vF0WbUrL6ZZm5mN5O2/kPrVvh3h5pU6i0ds4l1+oAHlVnfueMe09RbmW3dDoLmGubM2kHVIE7x0M+A7QTzzXc1+J1dSHFi8DJ/T9+0p30zYI+E95vzrA21Nhwts4RYIuSSdMlihBJ1yT4QNxv5Gq9FfaRYhJ809vfsfbHf1k7q1ypx8I7/t/EhsFl93HOEtIFt2xp7xhvpHGtuWaPyjYeg3reooFOWY7nn0z3wJnW2hth2/GWFkXZ2zhR4Bqfrcb4j7eQ9B85qbMTKJLRUYT2iEAKITIVVZTXbjrUHEmrsnBxPYH9is/T+G0oXLKDk7ewjVurdgoBxtCnbNNVaAHXIEXS50+6ZiVFZ+m8JqRmLrnfb5Rq3WuQAp7bwitYDAxETuczwipZhPYrkJHZzklnErF1dwNnGzL7H+R2qSuRO4iBmuAv4EgMBdtCRaf/wDGxHK86GmDG4Mbb8V2aWu3cbE84747H1l1eoK7HeZ5RiUGXtbK9473iVtzzpCMS3kgiSflNZOsqc68OD0qFxn57YHvHaWX7Pg7kniYYjK0azhrlwPcfEvBcNGgtxCxBjeQf0njp1NYwutRCFFY4xz7k87+3rONUGRWbJLflN3ZbP8AublyxedWUoUVxuNQ4Grqp3APtUPEPD1tqF9SkHkj2ktPqGDitzwZbHZrNo7q2x8L2wVPkwAkfMH9vWs/w7VlWNVh+X8S3U08sI1VuxGFEIUQhRCFEIUQnNj8RoQsASegHnS+ptNVZYSSL1HEqL7QO0dyRbQgsxjSPFv8uTMCNx9KzvDdKdTYbbzsO/aP2WfZ6x0j4jx/MXMFkeFuWdRxRW6DDkqdKk8SCAQOmokAn6VpXa3V1W9IqBUjYZ3I9v4iiUVuuev4u8mcVijh1QYhkv4a6pDkeIBwCZH+eAY/VqIIrPrpGpLGkFLFO3yJ/Y/iNowzmsAWbqf1i/l2AbFS5DW8JZk6VliATJCz8TmZLH+gr0tdYoUs27Hk+v8AAHYTLewueleI+LZS7gyuAuBAB4SuxB5gzuGPWd/OoM3mLlTIgdDfGJw9l+0rO/3bFDTeGwYiNZHII4Dj02PT1qrtP3W5lltIHxLxOuxn5GMfDXlCyfwmE79QD6kbg9dx03kLT5nSZE0gp1KZPRV0omQFRZgoJPE6AScCYs1eS1XiNgtfySelvb9Jt1aVSg8wbiZCvR6K2uyleg5x+MytQjK56hCm5SBmYs/lXnvEfEfJuBpbJxgjke009NpQ9Z6x8oIZp3wrUC6rJbLd5RrK+hthtPTWpE+048FmK3bl22vNpgCfUif2Mj5VEMCTiSKEAH1kJh86NzMzaU+BbbLHSQVJP1lflVSv1WEdpcU6agTyZM51jLNq0e/go3h0katU9I9quLhNzKlrLcRDz7JHwLs9sFsNdUow6gNI0k/uG9gfWV1S6hR6g5HzElVaaz7HYyKzLOUOFt4a0H0qxYs8Az4jACkwPEetJ0aBxqW1FuMkYwM4/P5S+y8GoVrn5mQJrUJ7RSWF2Cz83GsYd+bYcKf1LpYwfUD9hXlfGvDynVenfGfb/wBzW0moXoNbcy2ezGZ97aCtOtJUz1CnTP8ACfU1bodUtqBe4Er1FRRvaTVPyiFEIUQhRCeE0QiP23zvu0eX0rwNPPzJ2G/TeawL7G1N/lpuJo6atVHW3A9f2lYZGbeo4m+7qrObdtl3NtiCdR5iBsNuZPrWtqlsVRpqFBIAYj1wePf3i6MHY22HnYe0wzTJsVauC9bc31bi6vikf4+ZEckyCOas02u0tqGmxegj/ifX2ldlNqN1qcj1nJl2XjG4gJZt90mzORO3m25MGSQq+3rWpSj1Lmxuo+vt2H8xO11Y/CMCWxgsElq2tu2oCKIA/r6nk+dcLZMp4iV2ky+5g7v3nCnSGMMv5Z5gjqp39t+NqSsXym6l4j9LC0dLcyOz7EW8ZZGKtDRdQqt5QdweEcHynbV7eVctIcdfcSVQ6G6Dx2nFnGcm/as3ZjEWjDHqdJBR/wB2n1B9Kiz5AbvJLX0kjsY55F2iN/ElD8LWFdR+lgBrE+7/APbTFdhZvpFbagqZ94zg1fFxtPZpW3TJZalh/wCOf0/mXJeVRlHeBO3NR19vk0FwcHt7+0lpk63AIyJgrVnaHxF9VcFbAAHHqYzqNMtNeRuZkdxFaGr0aX19GBzFqLzW2SZrxN8IpY8KJPyq/wAuusdQA29hIZaw4JixlPaBvuV6/caStx1Sevw6ffcn5CoJYRX1GWtUDaFEXOzOa9xhsRfk95duaEB/wrJY+2vf5edVo/QmZbYnW4A4E6vs6w3ivYu4dKKuhSx9ixPsI+ZNTpGB1GQ1DZIUTxsy+/5haSCbKMSBxso1Sfchf2FcVjY+e0Cnl1+8fcWbZHd3NJ7yRoP5tpO3Xam+rBiuMyq8+yJMLiQt3X3DyVZSJj5g7qSJ23G/Wp2NYayasdXvO19PVhuJI5DluGNs4i5ZC2rYIcXCzMWERHwqQQR+WZ2rz+t1Op8waet8sx2xgDHv32+c0qaqivWV2HrF05iwvm/ZUWypDKEWFQbAAxtvsD5k+tbS6dRT5Nhzkd+TEjZ8fWoxiWt2OzUlcJdgePvSwB6SRH1X9hXk2xodY3cDA+k18+fSW9cSyrF4OqspkMAQfQ7ivQKwYAjvM0gg4M2VKchRCFEJH53iAlpvFpJHPOw5/aktfcEqIJ3MtpUs+0pHtdizib64e2DqLgb8+5PsdRjYAVDwupdPU2pfYAbf38o1qyG6aV57/wATeezqXLdyzbs3LN23p8dxjpuCeSRKngmANtqrHibpYtzuHU/8QNx7Ylf2ZWUooII9e8hcys3cJbNgXlfvviS2S2kA/LdjtEbgVqad6tbYLvLI6eCe/wD6i79dC9HVz/fzj/2SyT7rYAI/EaGuH1jj2HHvJ61oO2YhMc17O62Nyxca1dO5KkgMfWP5gj0payondTgxiu4AYYZEX7vaG5b1YfHprQ7F1ADDyJA8LDqCI46naqPMP3LBGPJH36zFXEWu6ukI4KOCuocOrcH6gH0ZfSqD8OQDL/vYJE4bywxnqpP8f5iuDcSRk12OxfdYhLjHwrauEn0Cao+sVZQcNkyi8ZTA7xy7GZxrsIL1ybr3LmkE7mPEY9BJ26cCm6nyozFLkwxxwI0VdF57NUW6aq05dQZbXc6fdM8ApHSeF1Vgl1BOTj5dozdrGYjoO2J6K1IlzFD7QM6Fu13Snxtz6f3/AE86Vvfq+AfWOaavHxGV/mOYkYe3ZXZVkkebEyxP/iPQepqjqzgdhGOnpy3cziuXm7tUJOwgDyBJP1LH+9qCcmSxgYklmGeObaWV8FpB4UHHqzH8xJ336ngUFmYe0Aipv3jT2b7vL7BvXv8AnXhK2/zBORP6ZO5J9OophWFS78xVgbjtx6zZ2Sa7i8W2KufBbBC+WoiIHoFJ+o867SCzdZkbiFUII09ocpXFWGtmA3KHyYcfLofQmm0bBisQMAGxFv7tfvdyuGJL6huVG0TMSh28vEOYrJ1aDR3G+qvqZ9h7H/Y/eaVTG+sIzYA/Mf6koy4e3aRMPZV0xHgZ3MXWGrSSqkajxqB2URNZy/aLbS97kFNwAPhBx3PHt3jHTWigIMg7Tn7E402MRcsO4KolwoZ2LbHw+jL4qY8WpS/TjUgYJxn++0r0jMr+SeMy3eyGM/Ct2W+JbSsP8p/ptUPDtT5imvH3Yaushy/YmMNacVhRCFEIpdrseAG0gakB8R4U/wDumIHNYGvt8y7yx22/GPaVMbniUZbbEXbjXbSXSWMakVjG3GoDmP73r04GmoqFNhGB64/SJPZbdYbFB+kZ8rx+MK93isM12wdma4sFV6kkjcAb77+tYmp0+iLeZprAr9gO59PaN1W2n4bFyJp7DZauJxj3hbC2rR1KgG2rhB6kAaj6gedehQPXUFZsnuT695luQWOBLJYVyQxI/OLd5k/AuBH9QDP+4Ef3yKg4Yj4ZNOkH4pW+dZlidQTFANp2J0BWAPQ6YEf2DWfYzNs3ImjUigZXiRHc6hoUiCZU+h/mIqA2ljcbTmu2yQpJ30tPyLfvRxxOc8zBU06dW4Xp9P3iK6TniAX1nZk2aNYv27sau7DGCYEuG/aWmpo5Q5lT19QxLU7I4y7ewqXL58TliNgPDJ07Dbj9op+vJXeIWhQ2FkzU5VFrtzjzbsgKxBIJ2McbDf3M/KldS+MCOaavOTNWedrltKFQy8CTyAfTz368VGzUdkkqtLvlpWGYYx7jm6x29Tv/ABk1SBgRkk52nC76jvv/AHsP79a7wJHkzIXPEOp5/p/fpXMbSWd50YW5pcNO6mdxO442OxrmSOJ3pB+9J/C5cbv4+Lum3bbfczduf5Qd4/xHbykb1NUUfE5lTWE/DWJM5PjHxWIt28ODaw1khiqkgaQdXi/UzEfx53NXVku22wlLgIvqTLEpqKYlc/aLl3d3kviQl0abmnzHP+5P/E1aPiT3HE6uzTZgMkwiuQ91sTdCatIOldOmRJmBKkAamjcbRXmb9drHTKqK1zjPcnvgc7fKatenqB3bqMh+0N0t3eJt2+50t3QCMCJQAqVZdjsSu2w0xWhoE6erTu3VkdW49djnP9xKbzxYox2lpZHmk3xfTe2/d2VHmHIMj2kfvWBo2bT39B5JOY/aosqwD2zLBr0cy4UQmNxoBPkKixwMwEqD7S8yfu/i0zwvXc8nyMTA52PFY/hqefquqwe/ymi58nTsV54zFzKMDfwtpryXkJCa7mH1bhImT5MFM8fXgu6rUafV2Ct0OM4D+/8AGZRSllSFgR8pozfOrrWdSXi1l0Foqx/E1bsxYAAAxtI2giOsX6TQ0pd0umHB6sjOMdsb/ke8hde5TKnYjHv7x27B4DucJbP5rn4h+fw/9oWtWzc4maDjedd7P1GJ+73D4ioKnoQSYG/JEfP1I3VsY1YYj4e59Pf5S9FFg53kmDV4ORkSk7TgzbKreIWHG/RhyP8A49DtUHrVxgyddrIciVdnWVthmZNviDKd4nfj0IPHnIrOdCrdLTRRwy9QkS94ncDYkwOOqk/uD9a53kxDFXAZP0H7k0LOmcwHh3+Hk+belBO8iNhGbJu2V6ygtSCWcQ1wswRIAgAbwIJ59AKZS4gRaykE5ljZHnVvFKz2g2lXKSwiSADI343ppHDjIij1lDgxS+0TE/iBPJBP1J/uaS1O9mI/pRisn3iA92Sd+d+f4niqwMSwmc3EbzH0FTkJpZt/CZ9TXcesjnfabEby68muSQmxImBvXJITvwYW434twog5hSzH0HSem5AHrxXV6f8AlByxHwx/7I52jOuHwmGK2l3uXGbcbctAgsTsBP0A2ZrfqOFG0StrC7scmO6x1IHqavJxKAMyF7V4MX8LeVfEVXUp/wAS77SN5G0jY6qlW284wxK3ymwl4Ja7q6zMGBZXIDFQWQGQw2ELO0Aikda9mnLWBwBtgEA7H7x5BjlAWwBSDn5/hOjtDlFmwihr1w39O1rULgX3bSsD5f1qnw/WajU2EhB0f+WME/mZPUUJWu7HPp6Rn7AZgLtm1aBg4dnuNvvyWU/Vo+VZfjNb06g3euMfONaN1NRXudpbuR4s3cPauNy6An3IrVocvWrHkiK2oEcqOxndVsrnHm11ltnSJPH1/lSutdlpYrJ1gFgDKO7e3la8lsS7F5cjck/DC+m8Dzj2inwVOlHszgYxk/jmNa04VEPzx7QbO7DXWW9gHS44KHRs7Bto4UyR70fYNQqB6rwQN9+Mjf3kfOrLEMhBkHm+Bsm/atYdXUPpB1zrDOxEEHiBH1rW8Oe9qy1xBOcDHGB3+piepFaEBJcaIAABwBAHoNhV5io4lX/aUCuLVvO0p+jOP5VYv3ZJciTnY7tV3mmzdPj/ACsfz/8A29OvvsULFOk+Ib1n/wCv+v0l+Bd//X6xymmgcjIi+MbRL7WZFeY94jG4szDEnTvO3pPl9OtJ6ipvvDeOUWr93gxG7giFjfdYOx3Mz9KUJ3jomq9B1dC0fTj9zFCzje003/XoefKI4/rXRtDtNDiJ/c/yqYkJK9j86GGxFtm+A+D4iAoYiWIAMwBx5xVyN0nMptXqXAnZ2vxve3XPm23mF6be0b0uX6nJlyr0IBFpySef2/jNWbSJ5nM14hjHPsJqW0hmeMCdzJPsTRO4MyA9Cf2FczDAm+2JHE/w/v51EywTbaI1DXJXqAQD8tiB7kGgQOe0unKhYsYVHVRZtaA51ciQD4upbgeZpx7kqUep4HrM0I1j8/WKuY9pbmIxNiygNu01y2Y4Z1JVgT6EbgV2rTlv8tvPYdh/JljOFXpr/H+8R+VY26fX6k1dFuZWOTrftX8XhcOVVyfCW6BGjbY7lGmfSs7xevT/AOO68EqDjb3G35iP6J7MMiczEdlFRg2KxllfFLLqlm33Ekqd/OKXPjDspXTUN7HGB+Et+xb5sYTb2FuBMRfw0+K6e7Vh5Izav+2T8qPGVe3T13dhufqP5nNGVrtOZdXZK9qsED4UuMi/5REfSYqHhrs2nBaS1a4s+YB/GTdPxaRXaKe62bSJ8R6xBmPXoPfrxWb4p/2d+My/T/f4lK5xiVuZlZ/ItszJ20qstJn/ACyT5k1LRq40FjDfPA/LEv1AUXoudxyZnbyXDtZKLicK7lp7xlUNBBmSHkmd9RnrUDrNQtoZqnVf/EE4z9RxI+QjKfiUn1nPgrLNm1pHbWbegFvMpZBn5sJrY8P6TpQyjAJJx8yYjq8+YQe38S0RV8WlS/aViNWMIH/TRVP7v/6xVg2XMmoithnKtG8HdT68xNCHDFG4P9xBs/eEs7sj2mZm+74iRdBgE7FiOQfJx1HX3+JB0OjOR/2z/wDX/X6S/a8f/L9Y4jzFNggjIixGDgxWz7smLhL2iAeqHYf6T0+f7UpZpc7pG6tVgYaJOZ5S9podSN5g+Y4jzHtSbIU+8I4jq243kTet8fLY8nr8hvXRvJczlvtIPz+XtVgErbie5ThNThzso6nqR0E+VcsbbE5WpLZM25piAXkAdeff0G3WuVrtJO0j1gjj/tn+NWYxKyczAIIruTO4E90+9chiHd+f7/0muZnAPWTGRZJcxF1FVG0kjU+nwhepnccf2amiMxkXsVBzLGv5Ll+BUXXt6j+UMdbMfRT4fnG1SchW8upep/09yZQvXYOpzhf7+MWe2eOvutm5cdALgLJZVg3drOzNBIJYbgn1ECIpjT1CtiTu/c/sPQSLtlcLsv8AeZsyjGvi8ysuU0d2OAIhFVivzgqJ6knjir1+7KWI7SzRUZASs8/sKM0cO5RLi+JgYgNZIJ/3Cq9b1fZiyDLDBA9wZfpiOsAnAmZyHAW7K3mfEvbYwp0xPy0Aweh4NYn/AFHxCy41L0Ajc78fnHzpqFXqYkiaMrxCYfNPAhCsNKLEEG5aXSIPBkgfOmLls1HhnxHJ7n5E5lShU1Ht/qXF2LOjvbI3FvSSfN31Fv5Ul4Q5ZG9M7RjWLw3rGeteJSJ7S6e68RIAMkDkgDj06b//ANrM8UZRUM+sY0wJfaUZndnvcfF1GCC3qKqNyiqzgKB5jwimtE7U6HKEdRON+ASQPy5ndSqvqMdgPxxNj5lhmGhssKpxqUeMDznQDP8AqqA0+oU9a6oFvTO364nPNqb4TWRDsZh9GZlCSxTvBJ5MAqP2rarfrpVgMZGYhYMORLTqMhKZ7bL/AMdiQepU/wDYlWLuCp7yXvPMPnNg4AYZ7KteW7qDBQsr4RDMNyxGoSOgANVVEk4Mm6jGZMYkNmhv4hWKmwgCpG76Z3TgCfiI5BPWRVgYY6cbZkcEHneSnY3tXrizebx8K36v/t/5f5viQdG0ZyMmv/8AP+vbtLwBePRv1juu8RvPEU2HUjqB2ipBBweZvvZELq6boGk9Duf/AINU2WKRjGZaisN84iV2t7AJaw9y8t5yV3IgDwnY8deKSKBdxHUtLHBlf2crtzLF29OBt5x/CoNacYEvWnfee4zFgeFdo+EDaB/fyrirJdQEg7hnn50wNosTmYOYEbifWuzhM9B9P6/WuSXaHB5+u37iic4jn2f7CXL9kXHu91qhkGnXKnz3WPTc0wtIIyYs2oIbAjhmGb2svspYT8S4iAKpPA/U8cTzA3PoKirPefLo4HLHj6ep/Kc6Avx2/hEzMMTbxFkO125dx927pS2q7KkqIABjqSASvXyksIq6f4K+O57n3zIOTYMn8JCYy2qtdUK3xBNbHWEjkSs77QOYFWnA2Tv3kBnbqPHaOH2b2dV69cPKoByTuxkmSSZ8Hn1q20YUCVncywhVEJXXa5Ac0sgqGB7uQeD4iIOxqOpJGlcg42Mu04BsGfWZYXNcddv3DZeyyqsGCTZTmPEVBZtp1CR8qwH0ugpoUWhgx4/8j+B49vWaS23s56MEflInKbzJmdp8TBY3ASRDAllIQjTsRJWI8vStSxUbw9l0+wC7dvmD7xP4vOzZzLn7Guwu30jnS7f4WaQB/sA+YNYvg5OGXsMf7j2sGyt/cRsraiMh+0wTuwX4UyR5gDg+kx71l+KdIrBPOdozpQS+BKM7RZhew+ON4gB2tys7wHDbkeYk7U74fpq9Ro/KbP3t4au01X5XsMCaB23xf61/2L/Sr/8AoWj/APE/iZR9vt9p09isYbmZBzsbneEj1IZv5VoLUKqgg4AxFXfrYsZa8VVmRlQfaLC5gzMDp0oTp2JGkAxIInY0EkfEJYmCMGcHbTKkwuJiy4dHRWWJkflIJ4nWrcExx0qvqOeriSx2kV94OkgNCsRqHPHWPT0q9viHUPrIgbxk7UHB6rf3SBC/iLDyHmT4mkEQYgHaPWuoeolWnCMYI2ljfZjmfeYV3vXF1I5WSdwukGWnqZO/WPOaQagVN0Jwd8enyl5brwx5kng+1tq4zeLSoPhEeIiOWH5Qeg2Pn5CSIH2XmcYldzxIztv2kQYS6E3LKV+IA7mPUnYzAH05HbKiqkmdqcM4xKju4rmIE+nr9KQ6BNItOHEW2Ikb/wBPrVgIB3lLAneRRumYMir8SjJnprkJvtEnYbk7Afyjr7VzEkDjcyyOxHYwqe+xKbgg20JOxGoEspA9IFXKq1jrfiK2WFz0pJDtP2wFubWHIL8Nc5C/5fM+vA9ehXVZq92ytf5t/AgStPO7enYRVx2c4VcCUCm5jLrFmuMFbuxKgieRqC7cncnbUKvdvLbpTYAYwJz746m5nEtlsLdsMx+7M1oMWLAvDbkkRKE8AEbj3Iqa+WRvIfGM4nTkVq/hls3gi3Vum53NpwG2UQbnd/EQVLAeXPlPat8jJwIPt2jN9l51W77edwD6LP8A6qkzdRlbDEeAahIyr+3ON0ZgHEEoqbHg7TH0NTaoWVFD3llbdLdU473aCyMP93sWXt23abhLgsRtIBg8gASegiN6zE8NuOo+0XuGYcbbfh/d944dTWK/LRSAeZn2exyvmOGZLbBV8CoTqM6GAMgD8x1TG254FGs07porAzZJ3J47iQR1a5SBgS5exoYXrwG6D43/AFXSQYHoq7fMVk+EhviP/GP6zHSuef2jbWxiISM7RIhsnvPhBB943g+h4ikPEunyct6y/T9XXhZRX2iYd++t3bhH4qFgvVfESJ9wQRTfgbqa2TvnP4zniC/ECOAMCbMn7I27uE75rpDlWIiNK6SdjtJ433EVTqvGbatX5Krtt8zmdr0StV15kJ2VxXd4uw/TvAD7N4T+zV6F9wZnS7wKUhKk+07fGkf/AKl/i1SX4hiTHEjMP2eD4B8St5Zt3NLoZEAhNOnbc6iZ6bjfzj26ZPkxdVoO/wAxUFbHynSIwW81spgjY7oG4W1rcgHSSyhxLGV1Ii/D1HqamxC4IkVBOY6fZswu4W/ZUAsbgJJ4hgF5iJGltqwvFarH1FbLkAjGffnH1jmlZVB6pP4bslatWQ9z4mY6pbTBLQAN9+nMzV1F9ulw7Dbv6j3+XrJ6gLqGIXtxEft1lF6yVurL4cD4h+U9dXyiDxzxNaWoc3gMDtiJ6YiokHmJougx/frSfTHg+Z0A7H6HeOv71DBlvE58RhgdxyKmrEcyp0B3Ez//AMK8bPfKodBOooZKGT8S8iRvO4g81cFyMiLFgGwY9fZv2XAVMXdENM2oM7EFZIE7mdgIM8idq6XSletz8hIN1WN0KJI9t8yui8uELdwjhZeGYsG4EICYnaBz1NSpqNo867gcL6fP1P5SJYV/AnPr/ET+3mFw+GvC3h7puiCLkMDpYGCogbHnczz6GWftLsN5WKgJhlaYK5iC94mzbVDoA2L3PEVJ8PhE7ydhAHWKLTjDATiA8ZnuV5TfxIdpFwCyC1y489ymrcajsTDsYngNt0IMLz3hu30mWaYy5l127Zw18P4FV3UGN9BYAHbcwNW+x2MzRZYCo23nVU941fZSkYS5tzeP/hboTiV2cx1qUhKX7W4jXi77D9ZA/wBPh/8ATTCjAnRGDOcgwdvBC7bbxwul9ZOskiRpmPM7ARFeY0fiGts1prcfDvtjgeuZq3aalaeoHecn2a2WOLLKNlttLfpmBPvyI9/KnPHrAumwTyRF9Iv+SXN2DSbd24D4HfwjrAHxH1YmfaKS8LUirJjetwGCjkCNFaUTnHm+HV7TqwkRJHtvS+rANLZGcSypirAiUx9omEa7b+9EwBc0Kn+Hif8AcIj3pXwK1Vs6DywzGNenwAD/AI8/WIK4lwpUOwU8qCQp9xwa9O1aFuogZ9Zlh2AwDPLYb4lnwxuBwentxUiw4MjiXvlWLF6zbujh0De0jcfXalGGDCV99rWAIaziANiO7Y+oll+oLfSuE43EmnpFjIMtbEv3a3FTwsQrNGpoB0gR4iSi7ek9BVmxIbM6cgECRWNsaHYHoSDtHFV2AA5EkpyIyZMWxFi3hittkF9JMDvgjFVJG0kDbxHiI6ijGBOHmWn2gzW1leFHcKg1eG0g8+rHqQBuT1MCd6StbbfkRnT1db4PErzD2cbmV6dRuAcs3htoPkIHsBJpXoaya/XVphtLHs5bcw9gG9eW50bbTM7RufEenSfKaKydH7p3Hp7j29pmXdGpbKjBil2h+z/D3la5hwbVyCQF+BjB2Kn4d9torSwjrkRIMyHBlYYfDu15LR2JaCfLkkkegmlWICkx34sgSTxt22BCKABvO5Pz3/lS6dR5jLdKjEluweORMXb1MyqQdWgjcaSQD5iaYqDB9otcVZN4/wCdZfiu9s4nBlb9m2wbuVhGj83JhiQW8iJ45qtqGFnWxyf7tJU21CspjGe80faJgExtu29jV95UeFSCpKnfSwO6sDwDuDPnIfoVukntELWVWAiB2Qy20ly8MXaZ72kpbtECFbfUzA7eDSDz6QSat8pwA3rOFlkPleS3cVcK2tLMpGxMSOpM7qsAmSPOok9WWJ4gMDAxJjJMtxJsYm5h2KWV8ThHjURsFABkjTcaJ8Jg9QKtIVdsbznxH5SAwGYMFdAqw0y3WNoj9+fPpUa7HOV9eYMgJDS3ew+ENrBWgRuwLn/USR/2xUpWxyZKZlixatXLh4RS3vA2+p2roGTOSlBh7jmVR3neVUtJ+Qqb3117MwHzIk1RjwJuXJsRBY2LiqASWZCoAAkmWAHApc6/TZC9YJO2Ac7ywU2EcGNf2eYcraxF5v8AlNpSB8TssnSPSHA+e1Ynj9ilkQfeG/tgxzw9T1Ey4exeEZMMGZgWunvDHAkKAo9lAqzQ1eXSPfeS1bhrNu20nqci08NcMJWfanAJiVxNuNCWUISNgLslh7iRBrBou+z6rzP/AJYxNB06qAvdt5WXZ/BWGS5exLN3dsqNK8szTA8429PfavReIX6gOtOnA6mycnsBM/T11kF7DsJ3X86t3VOFw2EVVu7DfxlvynbyMTJO07ilq9BbSw1OouyV/DHccyxrkYeVWnMafsxzHXYew3xWmkD/AAsSf2bV9RWq++8Rk92nykYrDXLX5iJQ+Tjcf09iarEAcHMpLDXXs3ARqRlMg8FSOv1rldgG3Il7ow5ElcC+FXDXUuWy11jNtwfhIBieNjq48wpPFWMmOOJAGTyYqzl9rDhrP/FJc75LiHUj2mKCdWuPHbDAQIBEwNU1RuQR2lm01dqdWOzA27C60dU7sL0QqLmr0HjLHy4pFwWeadJSujfg/rHTMs2XKcGli2oZjsjdGb87MJmeseoHFW2/CoK8xakedZluIj4DA4zMLhYFrsfE7mEWenkP8qj5Uv0GyaTWV6fjiWXgstOHtor3u8bhtj8o5JPSeo9qXGpGjsKDcdx6H2/iZ9wGp+IDEQO1eD04r7yLRt2xCeMBCzs2gsFJk7Md49etSGrW5sdz6fvJJUVXc8RKewzuiAqC+kDUdK7jSZPSDTVYJ7Tlrd46YHJbGAvKGuC7buKF7+CotsT8LKTAUwPEZg87TTgWypuphtE8pavSp+KWJlltrZiYI/cfX9jMefWpuQ0qXIk3aug7kCfP++KXIwMCTB3i72s7MYG4LmJxKunh8b22YEgRyokNwBweBUlZzhRAheZVWC7OX1Fo2Lg73EE6La3AtzQBqDN4gF23iZ22FNqUQEESB6jvIztDcv4V3wZugqGOpbbDS2qBLeukCNW6iOKqsfqYETqjaSGZZThguGs4Nzeu3FJdp2LFioWIBXTp8hsZ61ZUMZ9JFzLWwlrQir+lQv0EVIymKn2k5jpsrZU+K4ZI/wAK/wBWj6GpoN8zq7xYwuPvYA6RdVlceO2rgsjETwZ0uPYjbesq7TUeI5JQgjgkbEfPuPbmaCWWabvt+k255nV57UreD2HUW94DlwAzkqB4TtB6QwiZ2o0WhoS3DJhwerI4xwMHuPz2luo1DsmQfhO31jRkOHNjCWLQ3vXoaYkWxdIA284I9TBjisrXsNTrCBsMgRnRp019TfPEt/AYRbVtLa/CihR7ARW6ihVCjtM92LMWPedFSkYUQir2jw837a6PAx1u0bEoOD9BWJ4imLA/bH5x7TNhG334H1lK5raaxiblu0n4V5vAjDwspO0GR8LErIIiCPOt7Tump062ucFe45Hr68jmIujU2GsDI9Jty7CXbl1bLXO41H/lWQA+25LRxA/WSfQ0vfdTXUblXrx/ybJH09foJdWrswUnHsB/f1m45kmEzJ7luTbDaX6yDGv3ht/cU34eXfSJ5vOPy7fliL6kAWnplsKwIBBkESCOCOkVbKMSuPtDyo27ouokpdnVtID/AMtQ39waQ1FfS3Wu02dFd5lfltvj9J3ZfkGFzDBM9mz3WJQAMqEhSw3HhPhAcTBEQZ8qsTUOU2MWsoWq34gcGLOU9m3xiXBauk3rURaubSsBfCfyldIEER8I2qVOoJ2aGq06pgpuJu+zwG3jPxLT6rdq4RAMhtl3jePER6VEL1WZUiSditARx359pl2dsjH4thjLxBgs5bZyQY0idhBPltEUulLO3vHLdVXVXhBG3OM7sZWi2ME8sRqhiHUSY1MedRjgdB02m5m6PhKxKqo3nrLCRuO7Q46yr3cRbBVrHga2Vbu3Ph8YkMCSV22A95rOt8NOATnnfPpLBcnX0rwJDtiWaxZ+8ICbdlxcZ42B8SRMEtPg2HnvVPQFdvLPJGMfnGVyRl//AFFbE3cMqK9tC12PEtzUVBjeQSAfSvRl6VUdK/FMYJcxPU23tzJ2xmDrhu8vv8Q2taYaDMDfoRvxxV4s6aupjz2i/l9VoVF47yb7I/aAlrDrbxdu6wQhUuquoFegYkjdeAR0j5oKGC5A2jzgM+M7yezn7ScPZRWtI1xmEqJ0yD1MAx/e1WFNgc8+kpB3IxxIDGZ9czC3ibzIxsWFhbakrbLmYd2J3KyIUCTK7ATUg6VnIP1nVRnPSIu5fl937vcxNq6LRQFfDq1P+oyPgEFU25M+tSNpsQtjA95I0mtwnLGcFrIMVdtPjHRnSfFcLDpA31HUTwODUa2qx1MZyxLOrpxuY5fZzk+lTiWG7SqDyA2J+ZEewPnTHmBxkcSixCjdJ5jvcuBQWYwoBJJ4AFclcqbF5qb2L+9FSbdu4h9kDeEe5gmPMmoagA1moHDMDj8JfTswY8A7zsxnY1n/ABMLcS7abcS0Edd+h/Y+lZVPjIr/AMeoQqw22Gf79I5ZomJLVnInHYy9cRi7Ng3BpVFW5cUyDoUlipPOwCA+gpjz20+le8jGTkA+/H8ytk6rAg7bGWv2cwqXcYqlCLdi3rRTM6gVVWbqTHE77elYfhyeZaXbnn8ZpXk104B52lg1uzLhRCFEJw51hmuWXVPiI26Utq6TbUVEtocJYGMqrt3k7XLFtEUd5hretvOIAcCOTMNHWKR8L1HlallsOFO31l+qTrTzB6xT7N5rZw63b91y195VQBLb7sxJ2EsRz5HzrT8R0l2pZKaxhBuT29hKNPaidTsdzOnAZPcu2LmpFsWT41a4fG1zoSzdDJBMKN9hVVutrouUKxd+CBwF9MD/AHxJLS1iHbA5+snfs6z+R90umGSe7nqBMr7r09PathxkdY4MQ42MdsRZV1KsAykQQeDVJAIwZxWKnIiJatXMqxguKWbDXPCRMmOY35ZTuPMSPOknQUnIG01kY6uvpJ3E39r8svWLq5jgXHdt42I3Ck9T5o3UdDPntBwAepRLKHZx5Nkj8+7R2WuWMdhj3d9WAv2l6mJB/wASkBlLc8TFQO+GEmoKhqmOR2kp2lRr161jsvs6ok3GLIobTHILSSQSpETFXtWdmU/hFa7ekGqwfjIzPsZl+LAxLXWt3hsEs2wsEQRqmS3oykVP4G3zj58ysV21krgEfl+M5Mq7Q3mTuLrsUEuywo/DA31TGqYjcmS1VXXOlZGMsdsn39BJihHfqGwHYSNz3CObBF2FZL+qJPwXkFwADr5kn0A60uF8m/o9vzEYXFqA+8jcswjJ3eKJi0l9ULABmUgB1lTsQRMSYlY22loPnBMraoDKjvJ/OD9/x6pfxSm3pGm6inYQPDo6OTueR6mIqeOp8KfpKv8At1ZZd/Waszvd4/3LA/jJPdKxC6mjYxAgLsfEem+1WPq2K+UBiV16FQfOc5kXmvZO9gz+Ndt2tQ+FX1vHsomNueKjW4UHLQarzG+BSRHB8mxBwCYe3aXDYVPxLt6+YZz8ROhSW5ggEA7KOm9T4I9pZU3Q+QMn0mnJf+MVctsMq21XU97uoLhGUyFLat2P5jUmtRlCgGdFT0ubmxn0mXbXBrZWxl2Euu5JJddU7kgrqA2G5Zj5QDXCc4rUTtX/ACusMbMuwYtWrdpeEULPnA5+Z3p9RgYmUzFmLHvFDt7nRYjCWd2YjvI8z8Ke52J+XmasBCqXbYCCgk4EjLL4nL7a67Vp7Nw+ITq1EjgncDYGIBHNYdg0viVp6WYOo27fhNJfM0y/EoKnmc2Z2sFcsvfs67bAhTZ6FmmPSNidugiATVmmOuruFNuGHPV7D95x1oKF0yPaTnYLL2sYd8U6hDc2S4/ItgblRz4j7SAN6T8c1JaxalO3fHrJ6CnqPVjeWr2Jy8W8OrlSLl3xuzbsZJKz5eEjbpJ9aZ0lQSoYGCYauwtYRnYRhpqLQohCiEKIRN7S4QWO/u6v+cAAPI7gj+B+VYHiOmKMGHBOfr/uaOnfzAExxmVlmeWrlmLQx3tlxMMoJBHyiVMEERsYrYRz4jp2RT0uuB/faIjFD5YZBkQcXisdfURrIMhI/DX1IO0epkn14pjydJoKD29+5P8AfSc8y3UP+3aSWfYHcPbvB8VZUPeKKFGxABEbalkCOSPaCt4fqmXZ16a2OFycn898H9ZZqKQdwcsOY5dkO0y4u3DQLyjxL+ofqX0PUdD8q1XTpiEmcwwSXrbW7ihkbkfzB5BHnVZAIwZ1HZDlYrWcBicDItL96wxM9086kPO2k7g+x9huSuVsr/7fEeFlOo/7uxi12izIXJRMvtYdm6rbYOeu0KPpFLksRgrH6wle4sz9ZB28JeAIOu0h+Iurop+UEtU1qbg7CQsvQfdwx+k6bNllCMinSz6RiLqwBxJRPIDfVufUHarOoVYK7e/eU4a/IbfbgcRozfJrWBewXvaxfe33twwRp1kkjb4Y0nkbL13qh7AdQvoBn6yCAmlh34wJJ/azaZkULa2LooZWEtEkDSNzGoifUUuSW1WO+P1ltHStRJ7SHv4D7rlV63fUd5iWBVZ4K6dIH+WJLcbx5S+1a1Lud5ULHvt+EbCIuX4q5ZuK9uQ6eIFd49/LmOetVL/5CMMFA6Hkic/ZsSuIc6WGx7tRbJXqJg7mdyZP7V3rbq6pw01dBUfnOjPc9t3cSmIsrcBEMy3X7wFlIgCd9MAcmh2BbIEKq2CdBO3tGLGfaBbu4Y27y3brOo1gOLaTM7ES+0AevpU2tUjHTKV0rq2evaQHZLC4m47Lh3NtWA7y5GwAmBvuT6Aj14rlCOTtsJLU2VqB1bmWHlGR2rEsJe43xXH3Y+fsPb96dRAnEzLbms549Jwdru0y4VNKEG8w2H6R+o/yHWrVXMqxEzKnGFbvrypddpDIX/ERW5MEQWYHcTIB3+Ixm6vq1o8qslQNwcbEj8wM/jH6QKPicZ9vSMti3hxhicPaTEWdetkuXAvdbAfmUwAJJkzuSJmsOxtR9pAvco+MZA+9+EeUVeX8I6h6ekWsFlJx94m1at2LCRrJ2UDk7gSzHfaNhHHXde8aCnFthZjxnf8AL2iBXzn+BcCWfkeCXFYpGjvLNkyzMsW5ghVUdSCQd5gDpNYPh9DvZ5jDb9Zp3N5NXTnBPaWLW/MqFEIUQhRCFEJzZhgUvIUuLqU9P6HkGoPWrjDCSR2Q5WI2fZSt58RZvJ4Vtg22I3B3hgfrPtBrDD2aGwsvr+UeZFuqUd95WD5picNabCsGRyQVYCG0mdgeSDMgjjf5eg+xafU2rquR3Hv8vaIi561NY59Z3dksjYDvr2pbYYFLc6WuOsldiRMGYHU+nKnimvQ/4acE43b0Hf8AvaW6WhvvNnHp6zkxll+8N+yncXlux3SmSTp1SoH5gvxJxv6xTOk1HlKK3bqXpz1cY7YPt6GVXVdRLKMHPH9/SPHZXtYmJAR4S/8Ap6N6r/7efen2TG/aKRjioiRnhNdEMTyiESe2uYtfwIZE8P3kgN6KLic+pUn50leVK9RM1NGrJb0r6frMe2uVk4DDOl53QJbi3G2nSDO2+oAftWY1qHV4VdyJfUrBSr9jkmaczzXvMvwboGYrKweSbasvTfcj51VTka4n5Swoprf0Im4YMXUuY7NH1Np8FhNlQD4VO/JJ+HfqTvMbLVlR1MJn12FiK6yfpIX7NsvnEPcjZLcH1LmAPaA23tUtNkkmS13SihBzHPF9l8JcMtYUH/DKf+JFMNWp5ESF9gGAxmu12Swi/wDRHzZj/Fq55Sek79pt/wDIzbhuzmFttrSwgboTLR7apj5VIVqOBItc7DBMlBU5VFftR2tTDg27UPd+qofXzPp9amqZnQIqYLA3e6OYELfYPq0tJgAkF28yCBA4A36QMvV6tHvOiJK5HP7fX/UeppZUF2M+0mtFnFWLtzD2lZ3Ia7ZZoII1SyRw5n4uD5TIrLDX6S5K73IUfdYDO3ofUe3bO0bxXahZBnPIi49vXct4awQHdEt3iCNDMu5MjooHiI5Kkx1OvW3SjX3cAkrnkA/3b5xRjv5ackYPzj3kuRhR9zwzG65l3uOdCD4VJAXnoI3rBsezX39eAAP0mjQi6evqcy08my8WLKWgZCCJiJPJMdJJO1bVadChRM+x+ty3rO2pyEKIQohCiEKIQohI3P8AANessiGGjYn+BpXV6fzkx3EuotFbhjxK87U9nvvK4eyzC3fRIBIncJJBj8p0zInpWbo9W+jucOCV7j9xL7qhapdfWI1zMH1i1irlxLuHJCMo7yTxBBI8X6bk+U9DWydOvSbdMoKvyCcf0eoiwuLHpsOCv9/GdmVYRcFbbF31PeEkWbb/ABb9W9SOT0HqYpTVXPr7BpaT8I+8w/QfKW1KKVNr89hI/PsO33exirnhvXGaYGmR8StA4I8+YKzT2guUaizTV7ooGO+/cSjUITWth5Mlezvb10hMSC68Bx8Q9/1e/PvWo9XcROP+X5hbvrrtOrr6Hce45B9DVBGIYmnPswFjD3Lv6V2/zHYfuRVdjdKkiW0IHsAPEj8iwPeZdaw9+2VAYsQTpY+NmHG67HfrueKoqo+H44zqdSPNLVTozJVR8JaRQED7ADYBVc1kqg/6mfp+kZrJOkZu+P3kTkHZm7du3LLt3drDvqtELOsXDcPMjgADbin69OlV5tI32/KV36g21dKnnY/SLHbDMBdxPc2ASltu7tqPzONmb3LTv5RRYz3PvGNMqaarPePHZfJ/utgId7jHVcI6sensBA+XrWhWgRcTHutNrljJWpymeTRCcOZ5pasDVdcKOg6n2A3NSAJhgxCzvtjdv6kw6sltQSzDdyvEmPgG/Tz5qeFTHWef1kwueJw9m7WEfUl9XZ2HhKmIjooBktG+8zwBPOZ4m2sTD0EADn/ftHNKlL5D5zJvCr9zs9/Yui/YFwSBzoeFYN01BghB25aQJM5VjfbbfKuTofHPuOD9QTG1HkJlTlc/kZDY22pxTJl2tmuAqQsRBgkIei7btMRxtvWnpg506nW4+E5GeduCf2/OKWsquRSTvGjJ8r+5W0VbKtjLggkkM4J/KgAYADidp5O3GNrNY+scoh+DPA7x7SaRVHW0tHs12eTDKWJL3nHjdvrA8lmtPT6ZaRtzF9RqWuPsOBJumIvCiEKIQohCiEKIQohCiEiM4yVLrC6BF1B4SDE87H03I+dKarSrcp9cS6q9kHT2MrnOsrTEriEu2u7vKddtysOOkHqy7Dz524FZWm1V2gZQc47iN36ZLVDLj6esTceL2De3bxVlLwUTZLElY2+EgiV48LDbyFehWqrVKz0OVzzj9/f3mf5rIQLBnHEic7zi5iX1XCNtlVdgo9P605o9DXpE6a/qTyTKrr2tOTJHs3kwu2sRcKa3tqCluSszO/hIJ4MAHc0n4jrWptrrDYBO52P67S3T0BlZiMkdplhsvIK3cNfFtmCwpcqdbfkDD4jtMGIBWZmpDXMhK2oTgncDsP8Al7fv2nDpwcFTz2P6SVftVibMW8bhxcAIILDSZBkGRKNB32HMU1VZTeuamBEpZXrOGGIw4Ht1hH+IvbP+JZH1Wf3ipmthK9pJW8fhLrq4vW2dfh/E42j4SfInpS/2dA/mdO/rLPOs6OgHaSVvEAbq4B8wRVhXqGDKgSDmKeQ9mEwt97z3FYAfhFiJWZ1E9JiBI8zxNV109JJjN+pNqgYkxic/wyfFiLQ9AwJ+gk0xg+kVxIbHdvcMmyB7h9BpH1aD+1SFbGGJDXO1OMxMjD2gijlhvHu7Qo29Jqq66mjAsbc9v9Syupn+6MxXzTDMALrXlulyQxVixBEEAlgORxG2xqdGoFjFekjHr/f1nbKioByDOjsfi2t4kaQCWR1AJgE6SQCfIsoFLeLVCzTHPYg7fMCXaJ8WfOS+c5ZhryNiMNdS0yEa1khNXPgIHPlpBBjaKzNJqtVS66e9CwYbHG+PcfrneMW0I48ysgEfhmRNpHxbqtm2yFgBeuAMVJgFmYLKgSJgcnfrtoHo0dZa1s4+6Nth2G+8XLG1gqDnmPGUZbYsnucJ31zEXBpJabZMSTvpGhRBMT5cmsDUai/XOFxhfSaNGnWgdbyxOyPZwYW2S5D3nMs+7ETHhDN4tIj6kmtTT0Cpcd4vqL/MbbiMNXxeFEIUQhRCFEIUQhRCFEIUQhRCR+d5WMRaKaih6MOR/UHyqjUadbl6Wl1NxqbqERs/y8WLdm3ikW6gMTpldO/nuGC8deN+axXpu0tvWp57iPKtepyAPpEjP+wVwXHOFKvb06ghbxx5CRDDiCTO455OzofHa3Tpu2Pr2mZbpHXdeJyZbntu1fF5g9tlt6GsqvhaBpG5aVGw2IMEcmalqPD7LqPJUhgW6uoncZ52x+8sr1Cq/WdtsYnvY/C6r1zF3RptWw1yY8Orfjzjf5gUeK29NS6Ws5ZsD3xDSplzaeBkzkwuJfFNcFwkWTdF24RO0+BVH1ge0/lq22uvRovl46+npH6kyKM1xPV93Of9Td2iw1mxi7wa3Kd2DbtqSo1EIOV4Ahz61zQ236jSIUbByck7+v8AqFyVpaQRtjYTb2gyrDWH0TcVu57weIEapI0wVneDvNR0Gt1d69exHV08dvXadvopQ4OQcZmGP7O2bZtA3LkXE1zoUhF8O7eIbDUOKlR4lfarnpX4Tjk7n22PpIvpEUgEncZ4nIuRqtkXmFx0Nxlm0B4VUkamkHmDA2G3O9XHxBjb5S9KkAH4u5PbtKxpwF6jnGcbSIzBFW46o2pAx0nzWdj9K0aWZq1LjB7iLuqhiFO0Yc1tfc7eFNsLLprcsobWfCdJJB8IBiBHPnWJpW+3WXC0nY4G+MD1+cdsH2cJ099z/EmgbeHxeGvWhotYpIZeFBIUgx03K7e9Z2LdTpban3as5B77RoBa7FZfut2i72xsqlxba2yndgoDuQyfGpBPXxMCOm1a/g9jPUbC3V1b/I8Hb8Inq1VWwBjEhcsuMt22yLqcMCqgEyQdhA3PsK0r1FlbIxwDtFqyUYMI15b2S1armN7yws7W7duD03+EqojaIJPWOuNqvFV0+K6fiOOSf37xyrSvccnYekc8lym+6W7eCZkw4/6jKqjYwdigZ2JB3HXkishaLtW/XcOff/cf/wAVC4PI7R8ybs7YwxZra+NuXY6mPX5D0EVsU6dKhhRErb3sGGO0lqulMKIQohCiEKIQohCiEKIQohCiEKIQohML1pWBVlDA8giR9DXCAeZ0EjcRax/ZEd6L1lyhA+CJQiIgRGkH5xtttFZ2o8OSwHp2z+sbTWEJ0MMj1ixmmBN5LlnF2LioCSjlfhJ/S8RudxvB3HECs5DqtHhxnbnnEvsqptA6SMmKz9kiLJfB4hjPhuW3iCPWBB2MwV/etVfF6XcDUJ8jE20lleymQ+YYPE4UWrb22tqGLB7LE65AmSCRqgbcbTtTyNp9SzOrhiRjDdpRl6wFxjHpMM9zOzisRbuSyLAD6hMaWJ20zMgx04o0Wku0unevAJOcYPqPf0kr7a7bA2fnMO2GNTEYnXacMpUKJlYjz1ARuTvxU/CqX02n6LFwck+sjrHWyzKnMns9x4uabNq9YNtrIR2N1BpYMpnc6jsOBzPpWToqDVm2xG6gxIGDvsY5c/VhFIwRjOR6yMynHvh1Bw9+2VNxw1u66rsCNLiYIleYPPQ07qqE1LHzqznAIIBO5HH0Morc1D4GBGeDtIXtJft3MTcayPATtAiTAkgepk1o+H12V6dVs5EW1DK1hK8ToOdi5h0sX0Ld2fw3RgGA4gyCCI/gPKqfsLVXm+lgOrkEZHz2k/PVqxW447ib8UmKvPZ02LiKihbQZDpUCIJZ1CngEk7bVFE02nrfrcEtu2/OfYQLvaw6RxxJleyF5mF3GX1upEkW7pYn0krAHt8vOkLPF9Pp16NMu/y2/mXjTW2t/kMnsoyu0xZsvwrrcVYLap2P+JnI3j3pB7dXqzgnKxxNPVpz/k2jZk3ZBntg49muNqnQGAVR0B0Aaj18ulM0eHVr8TDeV2awq2Kdh6xvsWVRQqqFUCAAIAHpWiAAMCJEknJ5myuzkKIQohCiEKIQohCiEKIQohCiEKIQohCiEKIQohMblsMCGAIOxBEgiuEA8wBxxITGdl7JRltKLLH8yD+Incb+lKXaGqwYxiNJq7A2WOfnF/FdnMXbtBbbreIbaIQqOnxGDHuIpB/DHVupT+0ZXU0ux6hj85HZzlQUrdxGCD3Ts0Ww4Ye4kT5dRxxUU+20HpBOJAU0Wk8fXaQmOyPLrd3VcsuFcTo1OujrOmdQ9vp631+K61fhbG3tvIDw9HGV/WasX2WwC+AtcQt8NzXsPRgRA9/lseer4zqsHKjPpI/9PDDIMxs9nsuKlCzi4B8evmATI2C/KPrzXW8Z1XT1BROnw3BE9y7JcBc/BXDO79LiNcYnbqAYH0j24qB8S1tg+DGflJv4clf3j+cncqyp3/Dt5eiqu4drS2ipHBkjxGeog1ArrLxuxEm1Wnpwcj6byZyvs3i2LC/dC2yD4f8AmGffp8yfYVJPDS33/wApF9TUMGsbyTyfsTYsszMTeZhHjAgddhHPqZp2vR1pzv8AOVW6x7BgbfKMGGwqW1020VFHRQFH0FNKoUYEVZixyTN1dnIUQhRCFEIUQhRCFEIUQhRCFEIUQhRCFEIUQhRCFEIUQhRCFEIUQhRCYPaBIJAJHBI4rhAM7kzQ+X2mfWbaF/1FQW+sTXOhc5xOh2AwCcT21gLasWW2iseWCgE/MCaAqjcCBZjsTN6WwOAB7V3EjmZV2EKIQohCiEKIQohCiEKIQohCiEKIQohCiEKIQohCiEKIQohCiEKIQohCiEKIQohCiEKIQohCiEKIQohCiEKIQohCiEKIQohCiEKIQohCiEKIQohP/9k=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0" b="100000" l="0" r="100000">
                        <a14:foregroundMark x1="37333" y1="4889" x2="37333" y2="4889"/>
                        <a14:foregroundMark x1="80000" y1="14667" x2="80000" y2="14667"/>
                        <a14:foregroundMark x1="71556" y1="10222" x2="71556" y2="10222"/>
                        <a14:foregroundMark x1="10667" y1="24889" x2="10667" y2="24889"/>
                        <a14:foregroundMark x1="5778" y1="35111" x2="5778" y2="35111"/>
                        <a14:foregroundMark x1="7556" y1="68000" x2="7556" y2="68000"/>
                        <a14:foregroundMark x1="4000" y1="56000" x2="4000" y2="56000"/>
                        <a14:foregroundMark x1="17333" y1="16000" x2="17333" y2="16000"/>
                        <a14:backgroundMark x1="76889" y1="3556" x2="76889" y2="3556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2600" y="4724400"/>
            <a:ext cx="771367" cy="771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0" y="6576290"/>
            <a:ext cx="9144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bg1"/>
                </a:solidFill>
              </a:rPr>
              <a:t>Copyright © 2016 Human Engineering Research Laboratories</a:t>
            </a:r>
          </a:p>
        </p:txBody>
      </p:sp>
      <p:pic>
        <p:nvPicPr>
          <p:cNvPr id="2058" name="Picture 10" descr="C:\Users\printer\Downloads\COLOR_HERLPITT LOGO.jpg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9098" y="1066800"/>
            <a:ext cx="3865804" cy="21825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2588" y="3429000"/>
            <a:ext cx="8378825" cy="5318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  <a:latin typeface="Minion Pro" pitchFamily="18" charset="0"/>
              </a:rPr>
              <a:t> </a:t>
            </a:r>
            <a:r>
              <a:rPr lang="en-US" sz="24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105399" y="4038600"/>
            <a:ext cx="3357483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School of Health and Rehabilitation Sciences</a:t>
            </a:r>
          </a:p>
          <a:p>
            <a:r>
              <a:rPr lang="en-US" sz="12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School of Medicine</a:t>
            </a:r>
          </a:p>
          <a:p>
            <a:r>
              <a:rPr lang="en-US" sz="12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School of Engineering</a:t>
            </a:r>
          </a:p>
          <a:p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  <a:p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  <a:p>
            <a:r>
              <a:rPr lang="en-US" sz="12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VA Pittsburgh Healthcare System</a:t>
            </a:r>
          </a:p>
          <a:p>
            <a:r>
              <a:rPr lang="en-US" sz="12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VA Rehabilitation Research and Development</a:t>
            </a:r>
          </a:p>
          <a:p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  <a:p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  <a:p>
            <a:r>
              <a:rPr lang="en-US" sz="12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Center for Assistive Technology</a:t>
            </a:r>
          </a:p>
        </p:txBody>
      </p:sp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9098" y="4996411"/>
            <a:ext cx="1310093" cy="3717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3" name="Picture 15"/>
          <p:cNvPicPr>
            <a:picLocks noChangeAspect="1" noChangeArrowheads="1"/>
          </p:cNvPicPr>
          <p:nvPr/>
        </p:nvPicPr>
        <p:blipFill rotWithShape="1">
          <a:blip r:embed="rId6" cstate="print">
            <a:clrChange>
              <a:clrFrom>
                <a:srgbClr val="FDFDFD"/>
              </a:clrFrom>
              <a:clrTo>
                <a:srgbClr val="FDFDFD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1" t="28604" r="10487" b="43480"/>
          <a:stretch/>
        </p:blipFill>
        <p:spPr bwMode="auto">
          <a:xfrm>
            <a:off x="1371600" y="4084253"/>
            <a:ext cx="3352800" cy="522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000"/>
          <a:stretch/>
        </p:blipFill>
        <p:spPr bwMode="auto">
          <a:xfrm>
            <a:off x="2314929" y="5568127"/>
            <a:ext cx="1524000" cy="4094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382588" y="6033930"/>
            <a:ext cx="8378825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2000" b="1" u="sng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0"/>
            <a:ext cx="4381650" cy="904150"/>
          </a:xfrm>
          <a:prstGeom prst="rect">
            <a:avLst/>
          </a:prstGeom>
        </p:spPr>
      </p:pic>
      <p:pic>
        <p:nvPicPr>
          <p:cNvPr id="17" name="Picture 5" descr="Home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085" y="192129"/>
            <a:ext cx="4284908" cy="5198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324769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2B786EAF-9AEC-1B4B-83B1-4CC1F636133E}"/>
              </a:ext>
            </a:extLst>
          </p:cNvPr>
          <p:cNvSpPr/>
          <p:nvPr/>
        </p:nvSpPr>
        <p:spPr>
          <a:xfrm>
            <a:off x="533400" y="4075993"/>
            <a:ext cx="8305800" cy="2058959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84D3715-D3A5-5F4C-A209-0A32D45E0C6D}"/>
              </a:ext>
            </a:extLst>
          </p:cNvPr>
          <p:cNvSpPr/>
          <p:nvPr/>
        </p:nvSpPr>
        <p:spPr>
          <a:xfrm>
            <a:off x="533400" y="1784166"/>
            <a:ext cx="8305800" cy="1416234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451884" y="1177074"/>
            <a:ext cx="71628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Purpose of our Meeting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827A814-6810-0E4D-ADE1-781E0A8F0FDD}"/>
              </a:ext>
            </a:extLst>
          </p:cNvPr>
          <p:cNvSpPr txBox="1"/>
          <p:nvPr/>
        </p:nvSpPr>
        <p:spPr>
          <a:xfrm>
            <a:off x="685800" y="1828800"/>
            <a:ext cx="81622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purpose of this research study is to gather feedback from about the design and function of the Powered Personal Transfer System (PPTS) for further development</a:t>
            </a:r>
            <a:endParaRPr lang="en-US" sz="2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0AB2D17-40A5-9744-9378-A8310D68E7DF}"/>
              </a:ext>
            </a:extLst>
          </p:cNvPr>
          <p:cNvSpPr txBox="1"/>
          <p:nvPr/>
        </p:nvSpPr>
        <p:spPr>
          <a:xfrm>
            <a:off x="533400" y="4103628"/>
            <a:ext cx="822428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 would like to learn more about:</a:t>
            </a:r>
          </a:p>
          <a:p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Your overall thoughts on the current prototyp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What features you like most and least about the current prototyp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ny suggestions for improvements on the current prototyp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The target population of mobility users who could be best served by this technology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93480D1-CA91-9C41-91E3-7EE224A33FD5}"/>
              </a:ext>
            </a:extLst>
          </p:cNvPr>
          <p:cNvSpPr/>
          <p:nvPr/>
        </p:nvSpPr>
        <p:spPr>
          <a:xfrm>
            <a:off x="458062" y="3494107"/>
            <a:ext cx="71628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Our Discussion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5610283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E84D3715-D3A5-5F4C-A209-0A32D45E0C6D}"/>
              </a:ext>
            </a:extLst>
          </p:cNvPr>
          <p:cNvSpPr/>
          <p:nvPr/>
        </p:nvSpPr>
        <p:spPr>
          <a:xfrm>
            <a:off x="553995" y="1791032"/>
            <a:ext cx="8305800" cy="1416234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140575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Background: Why are we doing this? 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827A814-6810-0E4D-ADE1-781E0A8F0FDD}"/>
              </a:ext>
            </a:extLst>
          </p:cNvPr>
          <p:cNvSpPr txBox="1"/>
          <p:nvPr/>
        </p:nvSpPr>
        <p:spPr>
          <a:xfrm>
            <a:off x="685800" y="1828800"/>
            <a:ext cx="8162254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.</a:t>
            </a:r>
          </a:p>
          <a:p>
            <a:endParaRPr lang="en-US" dirty="0"/>
          </a:p>
          <a:p>
            <a:endParaRPr lang="en-US" sz="2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53A640-11B6-B046-9C31-C07D6C3C1B15}"/>
              </a:ext>
            </a:extLst>
          </p:cNvPr>
          <p:cNvSpPr txBox="1"/>
          <p:nvPr/>
        </p:nvSpPr>
        <p:spPr>
          <a:xfrm>
            <a:off x="548125" y="1709393"/>
            <a:ext cx="8291075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r>
              <a:rPr lang="en-US" dirty="0"/>
              <a:t>Caregivers and care recipients are susceptible to injury when attempting to safely transfer to and from a wheelchair. The PPTS may provide an alternative method to transfer those who are unable to get out of bed on their own without putting additional physical stress on the caregiver.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2667016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E84D3715-D3A5-5F4C-A209-0A32D45E0C6D}"/>
              </a:ext>
            </a:extLst>
          </p:cNvPr>
          <p:cNvSpPr/>
          <p:nvPr/>
        </p:nvSpPr>
        <p:spPr>
          <a:xfrm flipV="1">
            <a:off x="685800" y="1027212"/>
            <a:ext cx="8077200" cy="377328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Rectangle 28"/>
          <p:cNvSpPr/>
          <p:nvPr/>
        </p:nvSpPr>
        <p:spPr>
          <a:xfrm>
            <a:off x="76200" y="841566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Consent </a:t>
            </a:r>
            <a:endParaRPr lang="en-US" sz="36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11" name="Picture 10" descr="Text, letter&#10;&#10;Description automatically generated">
            <a:extLst>
              <a:ext uri="{FF2B5EF4-FFF2-40B4-BE49-F238E27FC236}">
                <a16:creationId xmlns:a16="http://schemas.microsoft.com/office/drawing/2014/main" id="{3A0D1031-7F3B-A44F-90FA-5F5D96CE61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46" y="1843794"/>
            <a:ext cx="4199854" cy="3986994"/>
          </a:xfrm>
          <a:prstGeom prst="rect">
            <a:avLst/>
          </a:prstGeom>
        </p:spPr>
      </p:pic>
      <p:pic>
        <p:nvPicPr>
          <p:cNvPr id="13" name="Picture 12" descr="Text, letter&#10;&#10;Description automatically generated">
            <a:extLst>
              <a:ext uri="{FF2B5EF4-FFF2-40B4-BE49-F238E27FC236}">
                <a16:creationId xmlns:a16="http://schemas.microsoft.com/office/drawing/2014/main" id="{BB024799-A33A-3340-97E7-4C8A61D404A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400" y="1946632"/>
            <a:ext cx="4654187" cy="3311168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82E0634E-FC66-F14A-8986-738E2597C9DB}"/>
              </a:ext>
            </a:extLst>
          </p:cNvPr>
          <p:cNvCxnSpPr/>
          <p:nvPr/>
        </p:nvCxnSpPr>
        <p:spPr>
          <a:xfrm>
            <a:off x="4321629" y="1600200"/>
            <a:ext cx="0" cy="468430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967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CF5C93E4-A47F-416B-BCE0-87C0DF38C98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16"/>
          <a:stretch/>
        </p:blipFill>
        <p:spPr>
          <a:xfrm>
            <a:off x="1535144" y="1066800"/>
            <a:ext cx="6161055" cy="529524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C9F894D-7EFD-474E-B4A7-64AEA1AA02CB}"/>
              </a:ext>
            </a:extLst>
          </p:cNvPr>
          <p:cNvSpPr/>
          <p:nvPr/>
        </p:nvSpPr>
        <p:spPr>
          <a:xfrm>
            <a:off x="43671" y="576179"/>
            <a:ext cx="9144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kern="1400" dirty="0">
                <a:solidFill>
                  <a:srgbClr val="92D050"/>
                </a:solidFill>
                <a:latin typeface="Minion Pro" pitchFamily="18" charset="0"/>
                <a:cs typeface="Narkisim" panose="020E0502050101010101" pitchFamily="34" charset="-79"/>
              </a:rPr>
              <a:t>Inclusion/Exclusion Criteria </a:t>
            </a:r>
            <a:endParaRPr lang="en-US" sz="2000" kern="1400" dirty="0">
              <a:solidFill>
                <a:srgbClr val="92D050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4EAF52F-EB63-49F1-9A04-1325CA0BC122}"/>
              </a:ext>
            </a:extLst>
          </p:cNvPr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B971752-A45C-43AF-B86C-37AF99BF1D25}"/>
              </a:ext>
            </a:extLst>
          </p:cNvPr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292BCBB-F08E-4DDD-9393-9DBCDB0710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5" descr="Home">
            <a:extLst>
              <a:ext uri="{FF2B5EF4-FFF2-40B4-BE49-F238E27FC236}">
                <a16:creationId xmlns:a16="http://schemas.microsoft.com/office/drawing/2014/main" id="{0FD2F374-7F22-4B41-93FB-F6F42B556E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428612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34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Focus Group Logistics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396875" y="1600200"/>
            <a:ext cx="830580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/>
              <a:t>Will last about 60 minute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/>
              <a:t>Feel free to use the </a:t>
            </a:r>
            <a:r>
              <a:rPr lang="en-US" dirty="0"/>
              <a:t>chat</a:t>
            </a:r>
            <a:r>
              <a:rPr lang="en-US" sz="2000" dirty="0"/>
              <a:t> function to ask any ques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/>
              <a:t>Feel free to excuse your self if you need to use the bathroom </a:t>
            </a:r>
            <a:endParaRPr lang="en-US" sz="24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55AE027-F1C8-8D4F-A986-4174251936FE}"/>
              </a:ext>
            </a:extLst>
          </p:cNvPr>
          <p:cNvSpPr/>
          <p:nvPr/>
        </p:nvSpPr>
        <p:spPr>
          <a:xfrm>
            <a:off x="105032" y="3118799"/>
            <a:ext cx="9144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Focus Ground Rules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1E61A0-3495-1147-A270-E388A075953A}"/>
              </a:ext>
            </a:extLst>
          </p:cNvPr>
          <p:cNvSpPr txBox="1"/>
          <p:nvPr/>
        </p:nvSpPr>
        <p:spPr>
          <a:xfrm>
            <a:off x="419100" y="3455798"/>
            <a:ext cx="8305800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pPr marL="285750" indent="-285750" fontAlgn="base">
              <a:buFont typeface="Arial" panose="020B0604020202020204" pitchFamily="34" charset="0"/>
              <a:buChar char="•"/>
            </a:pPr>
            <a:r>
              <a:rPr lang="en-US" sz="2000" dirty="0"/>
              <a:t>Everyone should participate and only one person talks at a time.</a:t>
            </a:r>
          </a:p>
          <a:p>
            <a:pPr marL="285750" indent="-285750" fontAlgn="base">
              <a:buFont typeface="Arial" panose="020B0604020202020204" pitchFamily="34" charset="0"/>
              <a:buChar char="•"/>
            </a:pPr>
            <a:r>
              <a:rPr lang="en-US" sz="2000" dirty="0"/>
              <a:t>State you number before speaking to keep it confidential </a:t>
            </a:r>
          </a:p>
          <a:p>
            <a:pPr marL="285750" indent="-285750" fontAlgn="base">
              <a:buFont typeface="Arial" panose="020B0604020202020204" pitchFamily="34" charset="0"/>
              <a:buChar char="•"/>
            </a:pPr>
            <a:r>
              <a:rPr lang="en-US" sz="2000" dirty="0"/>
              <a:t>It is important for us to hear everyone’s ideas and opinions. </a:t>
            </a:r>
          </a:p>
          <a:p>
            <a:pPr marL="285750" indent="-285750" fontAlgn="base">
              <a:buFont typeface="Arial" panose="020B0604020202020204" pitchFamily="34" charset="0"/>
              <a:buChar char="•"/>
            </a:pPr>
            <a:r>
              <a:rPr lang="en-US" sz="2000" dirty="0"/>
              <a:t>There are no right or wrong answers to the questions – just ideas, experiences, and opinions, which are all valuable. </a:t>
            </a:r>
          </a:p>
          <a:p>
            <a:pPr marL="285750" indent="-285750" fontAlgn="base">
              <a:buFont typeface="Arial" panose="020B0604020202020204" pitchFamily="34" charset="0"/>
              <a:buChar char="•"/>
            </a:pPr>
            <a:r>
              <a:rPr lang="en-US" sz="2000" dirty="0"/>
              <a:t>Speak loudly and clearly to increase recording quality. </a:t>
            </a:r>
          </a:p>
          <a:p>
            <a:pPr marL="285750" indent="-285750" fontAlgn="base">
              <a:buFont typeface="Arial" panose="020B0604020202020204" pitchFamily="34" charset="0"/>
              <a:buChar char="•"/>
            </a:pPr>
            <a:r>
              <a:rPr lang="en-US" sz="2000" dirty="0"/>
              <a:t>Turn off or silence cell phones if possible. </a:t>
            </a:r>
          </a:p>
          <a:p>
            <a:pPr marL="285750" indent="-285750" fontAlgn="base">
              <a:buFont typeface="Arial" panose="020B0604020202020204" pitchFamily="34" charset="0"/>
              <a:buChar char="•"/>
            </a:pPr>
            <a:r>
              <a:rPr lang="en-US" sz="2000" dirty="0"/>
              <a:t>Enjoy the discussions!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0494846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914400" y="2362200"/>
            <a:ext cx="7620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Start Focus Group</a:t>
            </a:r>
          </a:p>
          <a:p>
            <a:pPr algn="ctr"/>
            <a:endParaRPr lang="en-US" sz="3600" b="1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  <a:p>
            <a:pPr algn="ctr"/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AUDIO RECORDING BEGINS NOW</a:t>
            </a:r>
            <a:endParaRPr lang="en-US" sz="3200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26222ABF-0565-A34B-9B1C-0FD9637621AE}"/>
              </a:ext>
            </a:extLst>
          </p:cNvPr>
          <p:cNvSpPr/>
          <p:nvPr/>
        </p:nvSpPr>
        <p:spPr>
          <a:xfrm>
            <a:off x="1371600" y="2133600"/>
            <a:ext cx="6858000" cy="2209800"/>
          </a:xfrm>
          <a:prstGeom prst="rect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31710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printer\Downloads\HERLPITT LOGO-transparent-800x800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4089" y="-40282"/>
            <a:ext cx="1518161" cy="99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Hom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46" y="6553200"/>
            <a:ext cx="1913854" cy="232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42599"/>
            <a:ext cx="7315199" cy="443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en-US" sz="2000" b="1" kern="1400" dirty="0">
                <a:solidFill>
                  <a:srgbClr val="B9912B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 </a:t>
            </a:r>
            <a:r>
              <a:rPr lang="en-US" sz="20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Human Engineering Research Laborator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6440011"/>
            <a:ext cx="9099550" cy="458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9000"/>
              </a:lnSpc>
              <a:spcAft>
                <a:spcPts val="600"/>
              </a:spcAft>
            </a:pPr>
            <a:r>
              <a:rPr lang="en-US" sz="2000" kern="1400" dirty="0">
                <a:solidFill>
                  <a:srgbClr val="000000"/>
                </a:solidFill>
              </a:rPr>
              <a:t> </a:t>
            </a:r>
            <a:r>
              <a:rPr lang="en-US" sz="1600" b="1" kern="1400" dirty="0">
                <a:solidFill>
                  <a:srgbClr val="B9912B"/>
                </a:solidFill>
                <a:latin typeface="Minion Pro" pitchFamily="18" charset="0"/>
                <a:cs typeface="Narkisim" panose="020E0502050101010101" pitchFamily="34" charset="-79"/>
              </a:rPr>
              <a:t>www.herl.pitt.edu</a:t>
            </a:r>
            <a:endParaRPr lang="en-US" sz="1200" b="1" kern="1400" dirty="0">
              <a:solidFill>
                <a:srgbClr val="B9912B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6200" y="1318123"/>
            <a:ext cx="9144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kern="1400" dirty="0">
                <a:solidFill>
                  <a:srgbClr val="0E2B55"/>
                </a:solidFill>
                <a:latin typeface="Minion Pro" pitchFamily="18" charset="0"/>
                <a:cs typeface="Narkisim" panose="020E0502050101010101" pitchFamily="34" charset="-79"/>
              </a:rPr>
              <a:t>The Powered Personal Transfer System (PPTS)</a:t>
            </a:r>
            <a:endParaRPr lang="en-US" sz="3200" kern="1400" dirty="0">
              <a:solidFill>
                <a:srgbClr val="0E2B55"/>
              </a:solidFill>
              <a:latin typeface="Minion Pro" pitchFamily="18" charset="0"/>
              <a:cs typeface="Narkisim" panose="020E0502050101010101" pitchFamily="34" charset="-79"/>
            </a:endParaRPr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459234" y="6516905"/>
            <a:ext cx="1653016" cy="34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7435154-291C-0E47-B11B-5C5B1AE9EAC5}"/>
              </a:ext>
            </a:extLst>
          </p:cNvPr>
          <p:cNvSpPr txBox="1"/>
          <p:nvPr/>
        </p:nvSpPr>
        <p:spPr>
          <a:xfrm>
            <a:off x="396875" y="1600200"/>
            <a:ext cx="8305800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r>
              <a:rPr lang="en-US" sz="2000" dirty="0"/>
              <a:t>A system that consists of a hospital bed and powered wheelchair that provides a “no lift” solution for performing bed to wheelchair transfers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1E61A0-3495-1147-A270-E388A075953A}"/>
              </a:ext>
            </a:extLst>
          </p:cNvPr>
          <p:cNvSpPr txBox="1"/>
          <p:nvPr/>
        </p:nvSpPr>
        <p:spPr>
          <a:xfrm>
            <a:off x="419100" y="3455798"/>
            <a:ext cx="83058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417749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21</TotalTime>
  <Words>1073</Words>
  <Application>Microsoft Office PowerPoint</Application>
  <PresentationFormat>On-screen Show (4:3)</PresentationFormat>
  <Paragraphs>167</Paragraphs>
  <Slides>26</Slides>
  <Notes>6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1" baseType="lpstr">
      <vt:lpstr>Arial</vt:lpstr>
      <vt:lpstr>Calibri</vt:lpstr>
      <vt:lpstr>Minion Pro</vt:lpstr>
      <vt:lpstr>Narkisim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Lain</dc:creator>
  <cp:lastModifiedBy>Satpute, Shantanu A.</cp:lastModifiedBy>
  <cp:revision>63</cp:revision>
  <dcterms:created xsi:type="dcterms:W3CDTF">2013-04-17T19:36:13Z</dcterms:created>
  <dcterms:modified xsi:type="dcterms:W3CDTF">2021-06-18T14:42:18Z</dcterms:modified>
</cp:coreProperties>
</file>